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wdp" ContentType="image/vnd.ms-photo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4"/>
  </p:sldMasterIdLst>
  <p:notesMasterIdLst>
    <p:notesMasterId r:id="rId16"/>
  </p:notesMasterIdLst>
  <p:sldIdLst>
    <p:sldId id="350" r:id="rId5"/>
    <p:sldId id="351" r:id="rId6"/>
    <p:sldId id="352" r:id="rId7"/>
    <p:sldId id="359" r:id="rId8"/>
    <p:sldId id="338" r:id="rId9"/>
    <p:sldId id="349" r:id="rId10"/>
    <p:sldId id="339" r:id="rId11"/>
    <p:sldId id="346" r:id="rId12"/>
    <p:sldId id="358" r:id="rId13"/>
    <p:sldId id="356" r:id="rId14"/>
    <p:sldId id="357" r:id="rId15"/>
  </p:sldIdLst>
  <p:sldSz cx="6858000" cy="9144000" type="screen4x3"/>
  <p:notesSz cx="6810375" cy="99425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34" userDrawn="1">
          <p15:clr>
            <a:srgbClr val="A4A3A4"/>
          </p15:clr>
        </p15:guide>
        <p15:guide id="2" pos="1344" userDrawn="1">
          <p15:clr>
            <a:srgbClr val="A4A3A4"/>
          </p15:clr>
        </p15:guide>
        <p15:guide id="3" pos="1979" userDrawn="1">
          <p15:clr>
            <a:srgbClr val="A4A3A4"/>
          </p15:clr>
        </p15:guide>
        <p15:guide id="4" orient="horz" pos="5647" userDrawn="1">
          <p15:clr>
            <a:srgbClr val="A4A3A4"/>
          </p15:clr>
        </p15:guide>
        <p15:guide id="5" pos="2840" userDrawn="1">
          <p15:clr>
            <a:srgbClr val="A4A3A4"/>
          </p15:clr>
        </p15:guide>
        <p15:guide id="6" orient="horz" pos="1519" userDrawn="1">
          <p15:clr>
            <a:srgbClr val="A4A3A4"/>
          </p15:clr>
        </p15:guide>
        <p15:guide id="7" orient="horz" pos="5103" userDrawn="1">
          <p15:clr>
            <a:srgbClr val="A4A3A4"/>
          </p15:clr>
        </p15:guide>
        <p15:guide id="8" pos="119" userDrawn="1">
          <p15:clr>
            <a:srgbClr val="A4A3A4"/>
          </p15:clr>
        </p15:guide>
        <p15:guide id="9" pos="343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mela Maxwell" initials="PM" lastIdx="1" clrIdx="0">
    <p:extLst>
      <p:ext uri="{19B8F6BF-5375-455C-9EA6-DF929625EA0E}">
        <p15:presenceInfo xmlns:p15="http://schemas.microsoft.com/office/powerpoint/2012/main" userId="S-1-5-21-436374069-1547161642-1606980848-8843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614" autoAdjust="0"/>
    <p:restoredTop sz="96337" autoAdjust="0"/>
  </p:normalViewPr>
  <p:slideViewPr>
    <p:cSldViewPr showGuides="1">
      <p:cViewPr varScale="1">
        <p:scale>
          <a:sx n="96" d="100"/>
          <a:sy n="96" d="100"/>
        </p:scale>
        <p:origin x="2592" y="84"/>
      </p:cViewPr>
      <p:guideLst>
        <p:guide orient="horz" pos="3334"/>
        <p:guide pos="1344"/>
        <p:guide pos="1979"/>
        <p:guide orient="horz" pos="5647"/>
        <p:guide pos="2840"/>
        <p:guide orient="horz" pos="1519"/>
        <p:guide orient="horz" pos="5103"/>
        <p:guide pos="119"/>
        <p:guide pos="343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presProps" Target="presProps.xml"/><Relationship Id="rId3" Type="http://schemas.openxmlformats.org/officeDocument/2006/relationships/customXml" Target="../customXml/item3.xml"/><Relationship Id="rId21" Type="http://schemas.openxmlformats.org/officeDocument/2006/relationships/tableStyles" Target="tableStyle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10" Type="http://schemas.openxmlformats.org/officeDocument/2006/relationships/slide" Target="slides/slide6.xml"/><Relationship Id="rId19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image" Target="../media/image6.emf"/><Relationship Id="rId4" Type="http://schemas.openxmlformats.org/officeDocument/2006/relationships/image" Target="../media/image9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image" Target="../media/image16.emf"/><Relationship Id="rId4" Type="http://schemas.openxmlformats.org/officeDocument/2006/relationships/image" Target="../media/image19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51905" cy="497604"/>
          </a:xfrm>
          <a:prstGeom prst="rect">
            <a:avLst/>
          </a:prstGeom>
        </p:spPr>
        <p:txBody>
          <a:bodyPr vert="horz" lIns="91580" tIns="45790" rIns="91580" bIns="4579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6881" y="0"/>
            <a:ext cx="2951905" cy="497604"/>
          </a:xfrm>
          <a:prstGeom prst="rect">
            <a:avLst/>
          </a:prstGeom>
        </p:spPr>
        <p:txBody>
          <a:bodyPr vert="horz" lIns="91580" tIns="45790" rIns="91580" bIns="45790" rtlCol="0"/>
          <a:lstStyle>
            <a:lvl1pPr algn="r">
              <a:defRPr sz="1200"/>
            </a:lvl1pPr>
          </a:lstStyle>
          <a:p>
            <a:fld id="{09490F6E-532F-4FB7-B1DF-95D36D81414D}" type="datetimeFigureOut">
              <a:rPr lang="en-GB" smtClean="0"/>
              <a:pPr/>
              <a:t>11/03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8188" y="746125"/>
            <a:ext cx="2794000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580" tIns="45790" rIns="91580" bIns="4579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721" y="4723253"/>
            <a:ext cx="5448936" cy="4473654"/>
          </a:xfrm>
          <a:prstGeom prst="rect">
            <a:avLst/>
          </a:prstGeom>
        </p:spPr>
        <p:txBody>
          <a:bodyPr vert="horz" lIns="91580" tIns="45790" rIns="91580" bIns="4579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43320"/>
            <a:ext cx="2951905" cy="497604"/>
          </a:xfrm>
          <a:prstGeom prst="rect">
            <a:avLst/>
          </a:prstGeom>
        </p:spPr>
        <p:txBody>
          <a:bodyPr vert="horz" lIns="91580" tIns="45790" rIns="91580" bIns="4579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6881" y="9443320"/>
            <a:ext cx="2951905" cy="497604"/>
          </a:xfrm>
          <a:prstGeom prst="rect">
            <a:avLst/>
          </a:prstGeom>
        </p:spPr>
        <p:txBody>
          <a:bodyPr vert="horz" lIns="91580" tIns="45790" rIns="91580" bIns="45790" rtlCol="0" anchor="b"/>
          <a:lstStyle>
            <a:lvl1pPr algn="r">
              <a:defRPr sz="1200"/>
            </a:lvl1pPr>
          </a:lstStyle>
          <a:p>
            <a:fld id="{0EDEEA9F-C342-4D52-9BA5-137599C0F11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2190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E3B00-F806-CE44-8A42-2C3731FAA1FE}" type="datetime1">
              <a:rPr lang="en-GB" smtClean="0"/>
              <a:t>11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CA5E5-DFF8-48DA-A404-FC1D15D82D9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B549C-D1A6-E943-B9CC-706FC289BB36}" type="datetime1">
              <a:rPr lang="en-GB" smtClean="0"/>
              <a:t>11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CA5E5-DFF8-48DA-A404-FC1D15D82D9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7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7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A9938-0FEE-9B42-91C2-3787B948AC5F}" type="datetime1">
              <a:rPr lang="en-GB" smtClean="0"/>
              <a:t>11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CA5E5-DFF8-48DA-A404-FC1D15D82D9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968DB-535A-1F44-BB54-160CA8279813}" type="datetime1">
              <a:rPr lang="en-GB" smtClean="0"/>
              <a:t>11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CA5E5-DFF8-48DA-A404-FC1D15D82D9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2E1CD-2F44-EB4D-B1A8-1398B606D86D}" type="datetime1">
              <a:rPr lang="en-GB" smtClean="0"/>
              <a:t>11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CA5E5-DFF8-48DA-A404-FC1D15D82D9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62507-4B6E-8F4D-AE37-E7B66B89C735}" type="datetime1">
              <a:rPr lang="en-GB" smtClean="0"/>
              <a:t>11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CA5E5-DFF8-48DA-A404-FC1D15D82D9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0DA6E-175E-9E43-8BD3-586D89BA21E3}" type="datetime1">
              <a:rPr lang="en-GB" smtClean="0"/>
              <a:t>11/03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CA5E5-DFF8-48DA-A404-FC1D15D82D9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2C5C7-3BA9-1141-8D86-412AFD857D7A}" type="datetime1">
              <a:rPr lang="en-GB" smtClean="0"/>
              <a:t>11/03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CA5E5-DFF8-48DA-A404-FC1D15D82D9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C90F7-91DF-0F4F-B622-4DEFB2A89357}" type="datetime1">
              <a:rPr lang="en-GB" smtClean="0"/>
              <a:t>11/03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CA5E5-DFF8-48DA-A404-FC1D15D82D9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790DE1-6682-0245-AC4C-3900D4D9971A}" type="datetime1">
              <a:rPr lang="en-GB" smtClean="0"/>
              <a:t>11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CA5E5-DFF8-48DA-A404-FC1D15D82D9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B08F3-4188-A94D-BCF4-6991FE6EA416}" type="datetime1">
              <a:rPr lang="en-GB" smtClean="0"/>
              <a:t>11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CA5E5-DFF8-48DA-A404-FC1D15D82D9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C2B11C-3661-AE47-9AE3-81BEB9F75BDC}" type="datetime1">
              <a:rPr lang="en-GB" smtClean="0"/>
              <a:t>11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8CA5E5-DFF8-48DA-A404-FC1D15D82D9D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oleObject" Target="../embeddings/oleObject1.bin"/><Relationship Id="rId7" Type="http://schemas.openxmlformats.org/officeDocument/2006/relationships/image" Target="../media/image4.jpe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microsoft.com/office/2007/relationships/hdphoto" Target="../media/hdphoto1.wdp"/><Relationship Id="rId5" Type="http://schemas.openxmlformats.org/officeDocument/2006/relationships/image" Target="../media/image3.jpeg"/><Relationship Id="rId4" Type="http://schemas.openxmlformats.org/officeDocument/2006/relationships/image" Target="../media/image2.emf"/><Relationship Id="rId9" Type="http://schemas.openxmlformats.org/officeDocument/2006/relationships/image" Target="../media/image5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oleObject" Target="../embeddings/oleObject2.bin"/><Relationship Id="rId7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7.emf"/><Relationship Id="rId11" Type="http://schemas.openxmlformats.org/officeDocument/2006/relationships/image" Target="../media/image10.emf"/><Relationship Id="rId5" Type="http://schemas.openxmlformats.org/officeDocument/2006/relationships/oleObject" Target="../embeddings/oleObject3.bin"/><Relationship Id="rId10" Type="http://schemas.openxmlformats.org/officeDocument/2006/relationships/image" Target="../media/image9.emf"/><Relationship Id="rId4" Type="http://schemas.openxmlformats.org/officeDocument/2006/relationships/image" Target="../media/image6.emf"/><Relationship Id="rId9" Type="http://schemas.openxmlformats.org/officeDocument/2006/relationships/oleObject" Target="../embeddings/oleObject5.bin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microsoft.com/office/2007/relationships/hdphoto" Target="../media/hdphoto3.wdp"/><Relationship Id="rId7" Type="http://schemas.microsoft.com/office/2007/relationships/hdphoto" Target="../media/hdphoto5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microsoft.com/office/2007/relationships/hdphoto" Target="../media/hdphoto4.wdp"/><Relationship Id="rId10" Type="http://schemas.openxmlformats.org/officeDocument/2006/relationships/image" Target="../media/image15.emf"/><Relationship Id="rId4" Type="http://schemas.openxmlformats.org/officeDocument/2006/relationships/image" Target="../media/image12.png"/><Relationship Id="rId9" Type="http://schemas.microsoft.com/office/2007/relationships/hdphoto" Target="../media/hdphoto6.wdp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tiff"/><Relationship Id="rId13" Type="http://schemas.openxmlformats.org/officeDocument/2006/relationships/oleObject" Target="../embeddings/oleObject7.bin"/><Relationship Id="rId18" Type="http://schemas.openxmlformats.org/officeDocument/2006/relationships/image" Target="../media/image19.wmf"/><Relationship Id="rId3" Type="http://schemas.openxmlformats.org/officeDocument/2006/relationships/image" Target="../media/image20.png"/><Relationship Id="rId7" Type="http://schemas.microsoft.com/office/2007/relationships/hdphoto" Target="../media/hdphoto8.wdp"/><Relationship Id="rId12" Type="http://schemas.openxmlformats.org/officeDocument/2006/relationships/image" Target="../media/image16.emf"/><Relationship Id="rId17" Type="http://schemas.openxmlformats.org/officeDocument/2006/relationships/oleObject" Target="../embeddings/oleObject9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8.emf"/><Relationship Id="rId20" Type="http://schemas.openxmlformats.org/officeDocument/2006/relationships/image" Target="../media/image26.emf"/><Relationship Id="rId1" Type="http://schemas.openxmlformats.org/officeDocument/2006/relationships/vmlDrawing" Target="../drawings/vmlDrawing3.vml"/><Relationship Id="rId6" Type="http://schemas.openxmlformats.org/officeDocument/2006/relationships/image" Target="../media/image22.png"/><Relationship Id="rId11" Type="http://schemas.openxmlformats.org/officeDocument/2006/relationships/oleObject" Target="../embeddings/oleObject6.bin"/><Relationship Id="rId5" Type="http://schemas.openxmlformats.org/officeDocument/2006/relationships/image" Target="../media/image21.tiff"/><Relationship Id="rId15" Type="http://schemas.openxmlformats.org/officeDocument/2006/relationships/oleObject" Target="../embeddings/oleObject8.bin"/><Relationship Id="rId10" Type="http://schemas.microsoft.com/office/2007/relationships/hdphoto" Target="../media/hdphoto9.wdp"/><Relationship Id="rId19" Type="http://schemas.openxmlformats.org/officeDocument/2006/relationships/image" Target="../media/image25.emf"/><Relationship Id="rId4" Type="http://schemas.microsoft.com/office/2007/relationships/hdphoto" Target="../media/hdphoto7.wdp"/><Relationship Id="rId9" Type="http://schemas.openxmlformats.org/officeDocument/2006/relationships/image" Target="../media/image24.png"/><Relationship Id="rId14" Type="http://schemas.openxmlformats.org/officeDocument/2006/relationships/image" Target="../media/image17.emf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E4DEC20-4028-564D-954A-4B95650CAE0C}"/>
              </a:ext>
            </a:extLst>
          </p:cNvPr>
          <p:cNvSpPr txBox="1"/>
          <p:nvPr/>
        </p:nvSpPr>
        <p:spPr>
          <a:xfrm>
            <a:off x="15399" y="35496"/>
            <a:ext cx="23719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/>
              <a:t>SUPPLEMENTARY TABLE 1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BA5449D3-0F42-FC43-8920-91C36E30181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6028565"/>
              </p:ext>
            </p:extLst>
          </p:nvPr>
        </p:nvGraphicFramePr>
        <p:xfrm>
          <a:off x="460504" y="1331640"/>
          <a:ext cx="5776808" cy="1599750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968050">
                  <a:extLst>
                    <a:ext uri="{9D8B030D-6E8A-4147-A177-3AD203B41FA5}">
                      <a16:colId xmlns:a16="http://schemas.microsoft.com/office/drawing/2014/main" val="1930933483"/>
                    </a:ext>
                  </a:extLst>
                </a:gridCol>
                <a:gridCol w="707448">
                  <a:extLst>
                    <a:ext uri="{9D8B030D-6E8A-4147-A177-3AD203B41FA5}">
                      <a16:colId xmlns:a16="http://schemas.microsoft.com/office/drawing/2014/main" val="2347247894"/>
                    </a:ext>
                  </a:extLst>
                </a:gridCol>
                <a:gridCol w="1004759">
                  <a:extLst>
                    <a:ext uri="{9D8B030D-6E8A-4147-A177-3AD203B41FA5}">
                      <a16:colId xmlns:a16="http://schemas.microsoft.com/office/drawing/2014/main" val="3468711750"/>
                    </a:ext>
                  </a:extLst>
                </a:gridCol>
                <a:gridCol w="1368359">
                  <a:extLst>
                    <a:ext uri="{9D8B030D-6E8A-4147-A177-3AD203B41FA5}">
                      <a16:colId xmlns:a16="http://schemas.microsoft.com/office/drawing/2014/main" val="1005727566"/>
                    </a:ext>
                  </a:extLst>
                </a:gridCol>
                <a:gridCol w="1728192">
                  <a:extLst>
                    <a:ext uri="{9D8B030D-6E8A-4147-A177-3AD203B41FA5}">
                      <a16:colId xmlns:a16="http://schemas.microsoft.com/office/drawing/2014/main" val="1570478453"/>
                    </a:ext>
                  </a:extLst>
                </a:gridCol>
              </a:tblGrid>
              <a:tr h="38678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reatment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z</a:t>
                      </a:r>
                      <a:endParaRPr lang="en-US" sz="1100" b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z</a:t>
                      </a:r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 IgG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b="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nz</a:t>
                      </a: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+ VEGF </a:t>
                      </a:r>
                      <a:r>
                        <a:rPr lang="en-GB" sz="1100" b="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Ab</a:t>
                      </a:r>
                      <a:endParaRPr lang="en-US" sz="1100" b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b="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nz</a:t>
                      </a: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+ VEGF/IL-8 </a:t>
                      </a:r>
                      <a:r>
                        <a:rPr lang="en-GB" sz="1100" b="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Ab</a:t>
                      </a:r>
                      <a:endParaRPr lang="en-US" sz="1100" b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732029045"/>
                  </a:ext>
                </a:extLst>
              </a:tr>
              <a:tr h="3142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ay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tx1">
                        <a:lumMod val="75000"/>
                        <a:lumOff val="25000"/>
                      </a:schemeClr>
                    </a:solidFill>
                  </a:tcPr>
                </a:tc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i="1" dirty="0">
                          <a:solidFill>
                            <a:schemeClr val="bg1">
                              <a:lumMod val="95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US" sz="1100" dirty="0">
                          <a:solidFill>
                            <a:schemeClr val="bg1">
                              <a:lumMod val="95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value*</a:t>
                      </a:r>
                      <a:endParaRPr lang="en-GB" sz="1100" b="0" dirty="0">
                        <a:solidFill>
                          <a:schemeClr val="bg1">
                            <a:lumMod val="95000"/>
                          </a:schemeClr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2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07185148"/>
                  </a:ext>
                </a:extLst>
              </a:tr>
              <a:tr h="21503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GB" sz="11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tx1">
                        <a:lumMod val="75000"/>
                        <a:lumOff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6E-0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27242987"/>
                  </a:ext>
                </a:extLst>
              </a:tr>
              <a:tr h="26837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GB" sz="11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tx1">
                        <a:lumMod val="75000"/>
                        <a:lumOff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E-0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2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20371932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  <a:endParaRPr lang="en-GB" sz="11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tx1">
                        <a:lumMod val="75000"/>
                        <a:lumOff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3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3E-0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73337355"/>
                  </a:ext>
                </a:extLst>
              </a:tr>
              <a:tr h="24763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68580" marR="68580" marT="0" marB="0" anchor="ctr">
                    <a:solidFill>
                      <a:schemeClr val="tx1">
                        <a:lumMod val="75000"/>
                        <a:lumOff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5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2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83E-0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5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73408007"/>
                  </a:ext>
                </a:extLst>
              </a:tr>
            </a:tbl>
          </a:graphicData>
        </a:graphic>
      </p:graphicFrame>
      <p:sp>
        <p:nvSpPr>
          <p:cNvPr id="7" name="Rectangle 6">
            <a:extLst>
              <a:ext uri="{FF2B5EF4-FFF2-40B4-BE49-F238E27FC236}">
                <a16:creationId xmlns:a16="http://schemas.microsoft.com/office/drawing/2014/main" id="{74F89539-366F-2F42-9FF0-F06048C0D1DB}"/>
              </a:ext>
            </a:extLst>
          </p:cNvPr>
          <p:cNvSpPr/>
          <p:nvPr/>
        </p:nvSpPr>
        <p:spPr>
          <a:xfrm>
            <a:off x="437891" y="2924137"/>
            <a:ext cx="589479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000" i="1" dirty="0">
                <a:latin typeface="Arial" panose="020B0604020202020204" pitchFamily="34" charset="0"/>
                <a:ea typeface="Times New Roman" panose="02020603050405020304" pitchFamily="18" charset="0"/>
              </a:rPr>
              <a:t>Abbreviations: ENZ, Enzalutamide; 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</a:rPr>
              <a:t>IL-8, interleukin 8; VEGF, vascular endothelial growth factor A.</a:t>
            </a:r>
            <a:endParaRPr lang="en-GB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7E8E86F-3208-3245-B6B9-7C55E19A98D4}"/>
              </a:ext>
            </a:extLst>
          </p:cNvPr>
          <p:cNvSpPr/>
          <p:nvPr/>
        </p:nvSpPr>
        <p:spPr>
          <a:xfrm>
            <a:off x="437891" y="888559"/>
            <a:ext cx="5799421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</a:rPr>
              <a:t>Supplementary Table 1.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</a:rPr>
              <a:t>Statistical analysis of LNCaP xenograft area vessel coverage from day 7 to 28.</a:t>
            </a:r>
            <a:endParaRPr lang="en-GB" sz="11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F47DE4EA-D236-024F-BE91-3824E9F64FBF}"/>
              </a:ext>
            </a:extLst>
          </p:cNvPr>
          <p:cNvSpPr/>
          <p:nvPr/>
        </p:nvSpPr>
        <p:spPr>
          <a:xfrm>
            <a:off x="437891" y="3152853"/>
            <a:ext cx="588480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</a:rPr>
              <a:t>*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atistically significant differences were determined using a Mann-Whitney U test.</a:t>
            </a:r>
            <a:endParaRPr lang="en-US" sz="1000" dirty="0"/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BE4A0C60-23B4-934E-9B35-EDFA47E3B1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CA5E5-DFF8-48DA-A404-FC1D15D82D9D}" type="slidenum">
              <a:rPr lang="en-GB" smtClean="0"/>
              <a:pPr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661685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C848B302-C31D-2D4B-88FB-F491FBA0B337}"/>
              </a:ext>
            </a:extLst>
          </p:cNvPr>
          <p:cNvSpPr/>
          <p:nvPr/>
        </p:nvSpPr>
        <p:spPr>
          <a:xfrm>
            <a:off x="368660" y="611560"/>
            <a:ext cx="6120680" cy="80783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METHODS </a:t>
            </a:r>
          </a:p>
          <a:p>
            <a:pPr algn="just">
              <a:spcAft>
                <a:spcPts val="0"/>
              </a:spcAft>
            </a:pPr>
            <a:endParaRPr lang="en-GB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imer Sequences</a:t>
            </a:r>
            <a:r>
              <a:rPr lang="en-GB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imer sequences were as follows: </a:t>
            </a:r>
          </a:p>
          <a:p>
            <a:pPr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R</a:t>
            </a:r>
            <a:r>
              <a:rPr lang="en-US" sz="1200" baseline="-25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L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	Forward,5′-CGGAAGCTGAAGAAACTTGG-3′; </a:t>
            </a:r>
          </a:p>
          <a:p>
            <a:pPr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	Reverse,5′-CGTGTCCAGCACACACTACA-3′; </a:t>
            </a:r>
          </a:p>
          <a:p>
            <a:pPr>
              <a:spcAft>
                <a:spcPts val="0"/>
              </a:spcAft>
            </a:pPr>
            <a:endParaRPr lang="en-US" sz="1200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>
              <a:spcAft>
                <a:spcPts val="0"/>
              </a:spcAft>
            </a:pP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R-V7: 	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ward,5′-</a:t>
            </a:r>
            <a:r>
              <a:rPr lang="en-GB" sz="1200" dirty="0">
                <a:solidFill>
                  <a:srgbClr val="222222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AAAGAGCCGCTGAAGGGAA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3′; </a:t>
            </a:r>
          </a:p>
          <a:p>
            <a:pPr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	Reverse,5′-</a:t>
            </a:r>
            <a:r>
              <a:rPr lang="en-GB" sz="1200" dirty="0">
                <a:solidFill>
                  <a:srgbClr val="222222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CCAACCCGGAATTTTTCTCC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3′; </a:t>
            </a:r>
          </a:p>
          <a:p>
            <a:pPr>
              <a:spcAft>
                <a:spcPts val="0"/>
              </a:spcAft>
            </a:pPr>
            <a:endParaRPr lang="en-US" sz="1200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LK3: 	Forward,5′-TGAGCCTCCTGAAGAATCGA-3′;</a:t>
            </a:r>
          </a:p>
          <a:p>
            <a:pPr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	Reverse,5′-TTGCGCACACACGTCATT-3′.</a:t>
            </a:r>
          </a:p>
          <a:p>
            <a:pPr>
              <a:spcAft>
                <a:spcPts val="0"/>
              </a:spcAft>
            </a:pPr>
            <a:endParaRPr lang="en-GB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tibodies.</a:t>
            </a:r>
            <a:r>
              <a:rPr lang="en-GB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tibodies for immunoblotting were: anti-AR, (Millipore Cat# 06-680, RRID:AB_310214); anti-AR-V7, (Abcam Cat# ab198394, RRID:AB_2861275); anti-GAPDH, (Bio-Rad Cat# MCA4740, RRID:AB_2107457); anti-β-actin, (Sigma-Aldrich Cat# A1978, RRID:AB_476692). Antibodies for immunofluorescence were: anti-AR; (Millipore Cat# 06-680, RRID:AB_310214) and Alexa-fluor-568 (Molecular Probes Cat# A-11036, RRID:AB_10563566) antibodies. Antibodies for IHC were: anti-AR (Abcam Cat# ab9474, RRID:AB_307266) and anti-CD31 (Abcam Cat# ab28364, RRID:AB_726362).</a:t>
            </a: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endParaRPr lang="en-GB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360"/>
              </a:spcAft>
            </a:pPr>
            <a:r>
              <a:rPr lang="en-US" sz="1200" b="1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 vivo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models</a:t>
            </a:r>
            <a:endParaRPr lang="en-GB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360"/>
              </a:spcAft>
            </a:pP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rug administration</a:t>
            </a:r>
            <a:r>
              <a:rPr lang="en-GB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nzalutamide (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nz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was administered at 4mg/kg in 0.1% DMSO/corn oil.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nz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r vehicle-control (VC) was administered orally 1x/day. Human IL-8 and VEGF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Abs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IgG control were administered 3x/week via intraperitoneal injection, at final concentrations of 50, 100 and 150mg/mL respectively. </a:t>
            </a:r>
          </a:p>
          <a:p>
            <a:pPr algn="just">
              <a:lnSpc>
                <a:spcPct val="200000"/>
              </a:lnSpc>
              <a:spcAft>
                <a:spcPts val="360"/>
              </a:spcAft>
            </a:pPr>
            <a:endParaRPr lang="en-GB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C63A87C-0274-4D4E-9D81-DE133777502A}"/>
              </a:ext>
            </a:extLst>
          </p:cNvPr>
          <p:cNvSpPr txBox="1"/>
          <p:nvPr/>
        </p:nvSpPr>
        <p:spPr>
          <a:xfrm>
            <a:off x="15399" y="35496"/>
            <a:ext cx="2586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/>
              <a:t>SUPPLEMENTARY METHODS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EB71C20-FE34-E94F-BFF4-E4ABA32801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CA5E5-DFF8-48DA-A404-FC1D15D82D9D}" type="slidenum">
              <a:rPr lang="en-GB" smtClean="0"/>
              <a:pPr/>
              <a:t>10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510395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18823D5C-8152-F445-9D69-6908BDDC3CBE}"/>
              </a:ext>
            </a:extLst>
          </p:cNvPr>
          <p:cNvSpPr/>
          <p:nvPr/>
        </p:nvSpPr>
        <p:spPr>
          <a:xfrm>
            <a:off x="368660" y="611560"/>
            <a:ext cx="6120680" cy="67856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Xenograft study</a:t>
            </a:r>
            <a:r>
              <a:rPr lang="en-GB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NCaP cells (1×10</a:t>
            </a:r>
            <a:r>
              <a:rPr lang="en-US" sz="1200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7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atrigel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were implanted on the rear dorsum of 8-10-week-old male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alb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/c SCID mice (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nvigo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. When the tumor volume reached 100–200 mm</a:t>
            </a:r>
            <a:r>
              <a:rPr lang="en-US" sz="1200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3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mice were randomized to treatment groups. Tumor dimensions were measured as described (9) by calipers. Mice were sacrificed at days shown in treatment schematics. </a:t>
            </a:r>
            <a:endParaRPr lang="en-GB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 </a:t>
            </a:r>
            <a:endParaRPr lang="en-GB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360"/>
              </a:spcAft>
            </a:pP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orsal skin flap model</a:t>
            </a:r>
            <a:r>
              <a:rPr lang="en-GB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 viewing chamber was attached to a raised skin flap on the dorsal surface of the mouse (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alb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/c SCID) and a LNCaP tumor fragment was placed on the microvascular as described (10). Tumor vasculature was imaged weekly by stereomicroscope. Image analysis was performed using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ouptek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oftware (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ouptek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hotonics, China).</a:t>
            </a:r>
            <a:endParaRPr lang="en-GB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 </a:t>
            </a:r>
            <a:endParaRPr lang="en-GB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360"/>
              </a:spcAft>
            </a:pP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umor oxygenation</a:t>
            </a:r>
            <a:r>
              <a:rPr lang="en-GB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umor oxygenation was measured once weekly as described (9). </a:t>
            </a:r>
            <a:endParaRPr lang="en-GB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 </a:t>
            </a:r>
            <a:endParaRPr lang="en-GB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umor Growth</a:t>
            </a:r>
            <a:r>
              <a:rPr lang="en-GB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umor growth over 28 days (% T/C) was calculated using the equation: %T/C = (mean tumor volume on day 28 – mean starting tumor volume)/(mean control tumor volume on day 28 or day 29 – mean control starting tumor volume) x 100. </a:t>
            </a:r>
            <a:endParaRPr lang="en-GB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 </a:t>
            </a:r>
            <a:endParaRPr lang="en-GB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625A2AF-E8FA-7348-9BB3-0F5A2CBD3565}"/>
              </a:ext>
            </a:extLst>
          </p:cNvPr>
          <p:cNvSpPr txBox="1"/>
          <p:nvPr/>
        </p:nvSpPr>
        <p:spPr>
          <a:xfrm>
            <a:off x="15399" y="35496"/>
            <a:ext cx="2586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/>
              <a:t>SUPPLEMENTARY METHODS</a:t>
            </a: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14895881-BE59-8F43-BE4E-192824BDFC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CA5E5-DFF8-48DA-A404-FC1D15D82D9D}" type="slidenum">
              <a:rPr lang="en-GB" smtClean="0">
                <a:latin typeface="Arial" panose="020B0604020202020204" pitchFamily="34" charset="0"/>
                <a:cs typeface="Arial" panose="020B0604020202020204" pitchFamily="34" charset="0"/>
              </a:rPr>
              <a:pPr/>
              <a:t>11</a:t>
            </a:fld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2492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F1151EE-D192-144E-A45F-70BA881FAFEC}"/>
              </a:ext>
            </a:extLst>
          </p:cNvPr>
          <p:cNvSpPr txBox="1"/>
          <p:nvPr/>
        </p:nvSpPr>
        <p:spPr>
          <a:xfrm>
            <a:off x="15399" y="35496"/>
            <a:ext cx="23719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/>
              <a:t>SUPPLEMENTARY TABLE 2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7F6F4FF-D7DE-3C47-90F7-27D3D6341DB6}"/>
              </a:ext>
            </a:extLst>
          </p:cNvPr>
          <p:cNvSpPr/>
          <p:nvPr/>
        </p:nvSpPr>
        <p:spPr>
          <a:xfrm>
            <a:off x="393900" y="2719300"/>
            <a:ext cx="589479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000" i="1" dirty="0">
                <a:latin typeface="Arial" panose="020B0604020202020204" pitchFamily="34" charset="0"/>
                <a:ea typeface="Times New Roman" panose="02020603050405020304" pitchFamily="18" charset="0"/>
              </a:rPr>
              <a:t>Abbreviations: ENZ, Enzalutamide; 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</a:rPr>
              <a:t>IL-8, interleukin 8; VEGF, vascular endothelial growth factor A.</a:t>
            </a:r>
            <a:endParaRPr lang="en-GB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A828089D-AB9B-CE42-B2CE-C9AE72FBD019}"/>
              </a:ext>
            </a:extLst>
          </p:cNvPr>
          <p:cNvSpPr/>
          <p:nvPr/>
        </p:nvSpPr>
        <p:spPr>
          <a:xfrm>
            <a:off x="437949" y="1043608"/>
            <a:ext cx="5971224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Table 2.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tatistical analysis of LNCaP tumor volumes for all treatment groups at day 28.</a:t>
            </a:r>
            <a:endParaRPr lang="en-GB" sz="11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6CFCBD5-784F-2C45-8CA6-59386989DDED}"/>
              </a:ext>
            </a:extLst>
          </p:cNvPr>
          <p:cNvSpPr/>
          <p:nvPr/>
        </p:nvSpPr>
        <p:spPr>
          <a:xfrm>
            <a:off x="434007" y="2965521"/>
            <a:ext cx="5884809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</a:rPr>
              <a:t>*</a:t>
            </a:r>
            <a:r>
              <a:rPr lang="en-GB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umours were measured 3x/week using digital callipers. The length and width of the tumour was measured and the volume calculated using the formula volume (mm</a:t>
            </a:r>
            <a:r>
              <a:rPr lang="en-GB" sz="1000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3</a:t>
            </a:r>
            <a:r>
              <a:rPr lang="en-GB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=(length (mm) x width (mm)</a:t>
            </a:r>
            <a:r>
              <a:rPr lang="en-GB" sz="1000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</a:t>
            </a:r>
            <a:r>
              <a:rPr lang="en-GB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/2. Tumour volume presented from the study day 28.</a:t>
            </a:r>
          </a:p>
          <a:p>
            <a:pPr algn="just"/>
            <a:endParaRPr lang="en-US" sz="1000" dirty="0"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algn="just"/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</a:rPr>
              <a:t>**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mpared to ENZ + IgG; 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</a:rPr>
              <a:t>Analysis was performed using a 2-way ANOVA with Bonferroni post-tests, comparing the statistical significance of measured observations between treatment groups. </a:t>
            </a:r>
          </a:p>
          <a:p>
            <a:pPr algn="just"/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§</a:t>
            </a:r>
            <a:r>
              <a:rPr lang="en-GB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umbers in brackets show %T/C compared to Enzalutamide alone at day 28; (T = tumour; C = control)</a:t>
            </a:r>
            <a:endParaRPr lang="en-US" sz="1000" dirty="0"/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D0427B37-C387-6D49-9901-CD2B85B5D2C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84796810"/>
              </p:ext>
            </p:extLst>
          </p:nvPr>
        </p:nvGraphicFramePr>
        <p:xfrm>
          <a:off x="475079" y="1505273"/>
          <a:ext cx="5866406" cy="1198696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2276376">
                  <a:extLst>
                    <a:ext uri="{9D8B030D-6E8A-4147-A177-3AD203B41FA5}">
                      <a16:colId xmlns:a16="http://schemas.microsoft.com/office/drawing/2014/main" val="2428238539"/>
                    </a:ext>
                  </a:extLst>
                </a:gridCol>
                <a:gridCol w="1757665">
                  <a:extLst>
                    <a:ext uri="{9D8B030D-6E8A-4147-A177-3AD203B41FA5}">
                      <a16:colId xmlns:a16="http://schemas.microsoft.com/office/drawing/2014/main" val="1024786294"/>
                    </a:ext>
                  </a:extLst>
                </a:gridCol>
                <a:gridCol w="864096">
                  <a:extLst>
                    <a:ext uri="{9D8B030D-6E8A-4147-A177-3AD203B41FA5}">
                      <a16:colId xmlns:a16="http://schemas.microsoft.com/office/drawing/2014/main" val="459084542"/>
                    </a:ext>
                  </a:extLst>
                </a:gridCol>
                <a:gridCol w="968269">
                  <a:extLst>
                    <a:ext uri="{9D8B030D-6E8A-4147-A177-3AD203B41FA5}">
                      <a16:colId xmlns:a16="http://schemas.microsoft.com/office/drawing/2014/main" val="2001015267"/>
                    </a:ext>
                  </a:extLst>
                </a:gridCol>
              </a:tblGrid>
              <a:tr h="33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atment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 volume*  (± SD)</a:t>
                      </a:r>
                      <a:endParaRPr lang="en-GB" sz="11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value**</a:t>
                      </a:r>
                      <a:endParaRPr lang="en-GB" sz="11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T/C</a:t>
                      </a:r>
                      <a:r>
                        <a:rPr lang="en-US" sz="1100" b="0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§</a:t>
                      </a:r>
                      <a:endParaRPr lang="en-GB" sz="1100" b="0" baseline="30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061093569"/>
                  </a:ext>
                </a:extLst>
              </a:tr>
              <a:tr h="16638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</a:t>
                      </a:r>
                      <a:endParaRPr lang="en-GB" sz="11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6 (± 44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829680642"/>
                  </a:ext>
                </a:extLst>
              </a:tr>
              <a:tr h="15727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Z</a:t>
                      </a:r>
                      <a:endParaRPr lang="en-GB" sz="11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3 (± 90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779986401"/>
                  </a:ext>
                </a:extLst>
              </a:tr>
              <a:tr h="19540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Z + IgG</a:t>
                      </a:r>
                      <a:endParaRPr lang="en-GB" sz="11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4 (± 76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1(102.8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972076775"/>
                  </a:ext>
                </a:extLst>
              </a:tr>
              <a:tr h="9258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Z + anti-VEGF </a:t>
                      </a:r>
                      <a:r>
                        <a:rPr lang="en-US" sz="1100" b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b</a:t>
                      </a:r>
                      <a:endParaRPr lang="en-GB" sz="11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1 (± 33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2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7 (60.6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56247756"/>
                  </a:ext>
                </a:extLst>
              </a:tr>
              <a:tr h="16994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X + anti-VEGF/anti-IL-8 </a:t>
                      </a:r>
                      <a:r>
                        <a:rPr lang="en-US" sz="1100" b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b</a:t>
                      </a:r>
                      <a:endParaRPr lang="en-GB" sz="11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3 (± 23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 (2.9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184062973"/>
                  </a:ext>
                </a:extLst>
              </a:tr>
            </a:tbl>
          </a:graphicData>
        </a:graphic>
      </p:graphicFrame>
      <p:sp>
        <p:nvSpPr>
          <p:cNvPr id="13" name="Slide Number Placeholder 12">
            <a:extLst>
              <a:ext uri="{FF2B5EF4-FFF2-40B4-BE49-F238E27FC236}">
                <a16:creationId xmlns:a16="http://schemas.microsoft.com/office/drawing/2014/main" id="{04C236E4-219A-6847-A428-936D4B58FF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CA5E5-DFF8-48DA-A404-FC1D15D82D9D}" type="slidenum">
              <a:rPr lang="en-GB" smtClean="0"/>
              <a:pPr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4154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F263490-3708-1746-8B1D-C13E0C84D5F8}"/>
              </a:ext>
            </a:extLst>
          </p:cNvPr>
          <p:cNvSpPr txBox="1"/>
          <p:nvPr/>
        </p:nvSpPr>
        <p:spPr>
          <a:xfrm>
            <a:off x="15399" y="35496"/>
            <a:ext cx="23719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/>
              <a:t>SUPPLEMENTARY TABLE 3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CF1D727C-939F-8048-8949-EC7A42DF4BE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56917076"/>
              </p:ext>
            </p:extLst>
          </p:nvPr>
        </p:nvGraphicFramePr>
        <p:xfrm>
          <a:off x="504552" y="1531974"/>
          <a:ext cx="5855337" cy="1404349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2420392">
                  <a:extLst>
                    <a:ext uri="{9D8B030D-6E8A-4147-A177-3AD203B41FA5}">
                      <a16:colId xmlns:a16="http://schemas.microsoft.com/office/drawing/2014/main" val="1888584019"/>
                    </a:ext>
                  </a:extLst>
                </a:gridCol>
                <a:gridCol w="1584176">
                  <a:extLst>
                    <a:ext uri="{9D8B030D-6E8A-4147-A177-3AD203B41FA5}">
                      <a16:colId xmlns:a16="http://schemas.microsoft.com/office/drawing/2014/main" val="130260239"/>
                    </a:ext>
                  </a:extLst>
                </a:gridCol>
                <a:gridCol w="1008112">
                  <a:extLst>
                    <a:ext uri="{9D8B030D-6E8A-4147-A177-3AD203B41FA5}">
                      <a16:colId xmlns:a16="http://schemas.microsoft.com/office/drawing/2014/main" val="1340114576"/>
                    </a:ext>
                  </a:extLst>
                </a:gridCol>
                <a:gridCol w="842657">
                  <a:extLst>
                    <a:ext uri="{9D8B030D-6E8A-4147-A177-3AD203B41FA5}">
                      <a16:colId xmlns:a16="http://schemas.microsoft.com/office/drawing/2014/main" val="1275969298"/>
                    </a:ext>
                  </a:extLst>
                </a:gridCol>
              </a:tblGrid>
              <a:tr h="44773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atment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 volume* (± SD)</a:t>
                      </a:r>
                      <a:endParaRPr lang="en-GB" sz="11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 b="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value**</a:t>
                      </a:r>
                      <a:endParaRPr lang="en-GB" sz="11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T/C</a:t>
                      </a:r>
                      <a:r>
                        <a:rPr lang="en-US" sz="1100" b="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§</a:t>
                      </a:r>
                      <a:endParaRPr lang="en-GB" sz="11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69773585"/>
                  </a:ext>
                </a:extLst>
              </a:tr>
              <a:tr h="23653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</a:t>
                      </a:r>
                      <a:endParaRPr lang="en-GB" sz="11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5 (± 77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108189375"/>
                  </a:ext>
                </a:extLst>
              </a:tr>
              <a:tr h="20261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Z + IgG</a:t>
                      </a:r>
                      <a:endParaRPr lang="en-GB" sz="11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9 (± 25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1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44532772"/>
                  </a:ext>
                </a:extLst>
              </a:tr>
              <a:tr h="24071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 + anti-VEGF/anti-IL-8 </a:t>
                      </a:r>
                      <a:r>
                        <a:rPr lang="en-US" sz="1100" b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b</a:t>
                      </a:r>
                      <a:endParaRPr lang="en-GB" sz="11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7 (± 15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35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776613479"/>
                  </a:ext>
                </a:extLst>
              </a:tr>
              <a:tr h="27674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Z + anti-VEGF/anti-IL-8 </a:t>
                      </a:r>
                      <a:r>
                        <a:rPr lang="en-US" sz="1100" b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b</a:t>
                      </a:r>
                      <a:endParaRPr lang="en-GB" sz="11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 (± 15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7.8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917626018"/>
                  </a:ext>
                </a:extLst>
              </a:tr>
            </a:tbl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7F21456D-A782-6E4F-8F53-7D68A0F8B00E}"/>
              </a:ext>
            </a:extLst>
          </p:cNvPr>
          <p:cNvSpPr/>
          <p:nvPr/>
        </p:nvSpPr>
        <p:spPr>
          <a:xfrm>
            <a:off x="475080" y="1085999"/>
            <a:ext cx="5857666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</a:rPr>
              <a:t>Supplementary Table 3.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</a:rPr>
              <a:t>Statistical analysis of LNCaP-Parental tumor volumes at day 29 across all treatment groups. </a:t>
            </a:r>
            <a:endParaRPr lang="en-GB" sz="11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A9BCBF26-8C43-A34F-AE0A-E563AA85EA4E}"/>
              </a:ext>
            </a:extLst>
          </p:cNvPr>
          <p:cNvSpPr/>
          <p:nvPr/>
        </p:nvSpPr>
        <p:spPr>
          <a:xfrm>
            <a:off x="437950" y="2872937"/>
            <a:ext cx="589479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000" i="1" dirty="0">
                <a:latin typeface="Arial" panose="020B0604020202020204" pitchFamily="34" charset="0"/>
                <a:ea typeface="Times New Roman" panose="02020603050405020304" pitchFamily="18" charset="0"/>
              </a:rPr>
              <a:t>Abbreviations: ENZ, Enzalutamide; 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</a:rPr>
              <a:t>IL-8, interleukin 8; VEGF, vascular endothelial growth factor A.</a:t>
            </a:r>
            <a:endParaRPr lang="en-GB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6C8AADC1-FA54-6F4F-AF63-B39AAE8E9E95}"/>
              </a:ext>
            </a:extLst>
          </p:cNvPr>
          <p:cNvSpPr/>
          <p:nvPr/>
        </p:nvSpPr>
        <p:spPr>
          <a:xfrm>
            <a:off x="437950" y="3099893"/>
            <a:ext cx="5884809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</a:rPr>
              <a:t>*</a:t>
            </a:r>
            <a:r>
              <a:rPr lang="en-GB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umours were measured 3x/ week using digital callipers. The length and width of the tumour was measured and the volume calculated using the formula volume (mm</a:t>
            </a:r>
            <a:r>
              <a:rPr lang="en-GB" sz="1000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3</a:t>
            </a:r>
            <a:r>
              <a:rPr lang="en-GB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=(length (mm) x width (mm)</a:t>
            </a:r>
            <a:r>
              <a:rPr lang="en-GB" sz="1000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</a:t>
            </a:r>
            <a:r>
              <a:rPr lang="en-GB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/2. Tumour volume presented from study day 29.</a:t>
            </a:r>
          </a:p>
          <a:p>
            <a:pPr algn="just"/>
            <a:endParaRPr lang="en-US" sz="1000" dirty="0"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algn="just"/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</a:rPr>
              <a:t>**Compared to vehicle control (VC); Analysis was performed using a 2-way ANOVA with Bonferroni post-tests, comparing the statistical significance of measured observations between treatment groups. </a:t>
            </a:r>
          </a:p>
          <a:p>
            <a:pPr algn="just"/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§ </a:t>
            </a:r>
            <a:r>
              <a:rPr lang="en-GB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%T/C for T = tumour; C = control at day 29.</a:t>
            </a:r>
            <a:endParaRPr lang="en-US" sz="1000" dirty="0"/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EDE84145-05EA-1646-A75F-8A9D97566D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CA5E5-DFF8-48DA-A404-FC1D15D82D9D}" type="slidenum">
              <a:rPr lang="en-GB" smtClean="0"/>
              <a:pPr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83335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D854966F-BA25-0747-B6DC-F92D9EE7D27C}"/>
              </a:ext>
            </a:extLst>
          </p:cNvPr>
          <p:cNvSpPr txBox="1"/>
          <p:nvPr/>
        </p:nvSpPr>
        <p:spPr>
          <a:xfrm>
            <a:off x="15399" y="35496"/>
            <a:ext cx="25884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/>
              <a:t>SUPPLEMENTARY FIGURE 1</a:t>
            </a: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6CFCB8C5-E57D-A747-8FD0-21C67B7970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CA5E5-DFF8-48DA-A404-FC1D15D82D9D}" type="slidenum">
              <a:rPr lang="en-GB" smtClean="0"/>
              <a:pPr/>
              <a:t>4</a:t>
            </a:fld>
            <a:endParaRPr lang="en-GB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A0E0F17C-DEE4-A44C-9AD2-2F91D6460E74}"/>
              </a:ext>
            </a:extLst>
          </p:cNvPr>
          <p:cNvSpPr/>
          <p:nvPr/>
        </p:nvSpPr>
        <p:spPr>
          <a:xfrm>
            <a:off x="332656" y="3331303"/>
            <a:ext cx="6005465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13335" algn="just">
              <a:spcAft>
                <a:spcPts val="0"/>
              </a:spcAft>
              <a:tabLst>
                <a:tab pos="90170" algn="l"/>
              </a:tabLst>
            </a:pPr>
            <a:r>
              <a:rPr lang="en-US" sz="1100" b="1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1.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drogen receptor (AR) expression in HUVEC and HMEC cells. </a:t>
            </a:r>
            <a:endParaRPr lang="en-GB" sz="11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5DB0F3B-C077-C44A-A8EC-137FA19725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76872" y="982916"/>
            <a:ext cx="1810564" cy="19549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73119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1073775"/>
              </p:ext>
            </p:extLst>
          </p:nvPr>
        </p:nvGraphicFramePr>
        <p:xfrm>
          <a:off x="430212" y="1041369"/>
          <a:ext cx="2998788" cy="2312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2" name="Prism 8" r:id="rId3" imgW="3485033" imgH="2684948" progId="Prism8.Document">
                  <p:embed/>
                </p:oleObj>
              </mc:Choice>
              <mc:Fallback>
                <p:oleObj name="Prism 8" r:id="rId3" imgW="3485033" imgH="2684948" progId="Prism8.Document">
                  <p:embed/>
                  <p:pic>
                    <p:nvPicPr>
                      <p:cNvPr id="3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30212" y="1041369"/>
                        <a:ext cx="2998788" cy="23129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63199" y="895271"/>
            <a:ext cx="908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(A)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3696013" y="1296620"/>
            <a:ext cx="1385819" cy="1305579"/>
            <a:chOff x="91352" y="7334803"/>
            <a:chExt cx="1385819" cy="1305579"/>
          </a:xfrm>
        </p:grpSpPr>
        <p:pic>
          <p:nvPicPr>
            <p:cNvPr id="7" name="Picture 14" descr="C:\Users\Pamela Maxwell\Desktop\Angiogenesis May 2107\F4 PC3 + ENZ 1.jpg"/>
            <p:cNvPicPr preferRelativeResize="0">
              <a:picLocks noChangeArrowheads="1"/>
            </p:cNvPicPr>
            <p:nvPr/>
          </p:nvPicPr>
          <p:blipFill>
            <a:blip r:embed="rId5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14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0771" y="8024782"/>
              <a:ext cx="896400" cy="6156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15" descr="C:\Users\Pamela Maxwell\Desktop\Angiogenesis May 2107\C4 PC3 + DMSO 4.jpg"/>
            <p:cNvPicPr preferRelativeResize="0">
              <a:picLocks noChangeArrowheads="1"/>
            </p:cNvPicPr>
            <p:nvPr/>
          </p:nvPicPr>
          <p:blipFill>
            <a:blip r:embed="rId7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14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0771" y="7334803"/>
              <a:ext cx="896400" cy="6156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" name="Rectangle 8"/>
            <p:cNvSpPr/>
            <p:nvPr/>
          </p:nvSpPr>
          <p:spPr>
            <a:xfrm>
              <a:off x="91352" y="7511798"/>
              <a:ext cx="708486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100" dirty="0"/>
                <a:t>DMSO </a:t>
              </a:r>
            </a:p>
          </p:txBody>
        </p:sp>
        <p:sp>
          <p:nvSpPr>
            <p:cNvPr id="10" name="Rectangle 9"/>
            <p:cNvSpPr/>
            <p:nvPr/>
          </p:nvSpPr>
          <p:spPr>
            <a:xfrm>
              <a:off x="193138" y="8180404"/>
              <a:ext cx="38343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100" dirty="0" err="1"/>
                <a:t>Enz</a:t>
              </a:r>
              <a:endParaRPr lang="en-GB" sz="1100" dirty="0"/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3435041" y="902730"/>
            <a:ext cx="908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(B)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1B8C1FE0-32C2-F245-AEE2-5371C7D7D128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b="8968"/>
          <a:stretch/>
        </p:blipFill>
        <p:spPr>
          <a:xfrm>
            <a:off x="5127122" y="1207137"/>
            <a:ext cx="1422400" cy="1757288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D854966F-BA25-0747-B6DC-F92D9EE7D27C}"/>
              </a:ext>
            </a:extLst>
          </p:cNvPr>
          <p:cNvSpPr txBox="1"/>
          <p:nvPr/>
        </p:nvSpPr>
        <p:spPr>
          <a:xfrm>
            <a:off x="15399" y="35496"/>
            <a:ext cx="24906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/>
              <a:t>SUPPLEMENTARY FIGURE 2</a:t>
            </a: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6CFCB8C5-E57D-A747-8FD0-21C67B7970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CA5E5-DFF8-48DA-A404-FC1D15D82D9D}" type="slidenum">
              <a:rPr lang="en-GB" smtClean="0"/>
              <a:pPr/>
              <a:t>5</a:t>
            </a:fld>
            <a:endParaRPr lang="en-GB"/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874D2F5A-7A5E-2142-94E8-004C6C18FA7D}"/>
              </a:ext>
            </a:extLst>
          </p:cNvPr>
          <p:cNvCxnSpPr>
            <a:cxnSpLocks/>
          </p:cNvCxnSpPr>
          <p:nvPr/>
        </p:nvCxnSpPr>
        <p:spPr>
          <a:xfrm>
            <a:off x="5651099" y="1388294"/>
            <a:ext cx="3600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430BF7E4-0318-CD4D-B1EB-40104408208F}"/>
              </a:ext>
            </a:extLst>
          </p:cNvPr>
          <p:cNvSpPr txBox="1"/>
          <p:nvPr/>
        </p:nvSpPr>
        <p:spPr>
          <a:xfrm>
            <a:off x="5651099" y="1172270"/>
            <a:ext cx="3828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A0E0F17C-DEE4-A44C-9AD2-2F91D6460E74}"/>
              </a:ext>
            </a:extLst>
          </p:cNvPr>
          <p:cNvSpPr/>
          <p:nvPr/>
        </p:nvSpPr>
        <p:spPr>
          <a:xfrm>
            <a:off x="332656" y="3685972"/>
            <a:ext cx="6005465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13335" algn="just">
              <a:spcAft>
                <a:spcPts val="0"/>
              </a:spcAft>
              <a:tabLst>
                <a:tab pos="90170" algn="l"/>
              </a:tabLst>
            </a:pPr>
            <a:r>
              <a:rPr lang="en-US" sz="1100" b="1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2.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drogen receptor (AR)-independent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C3 prostate cancer cells do not respond to androgen-signaling inhibitor Enzalutamide. (A)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Effect of increasing concentrations of Enzalutamide (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nz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on the viability of PC3 cells over 72h. Control cells were treated with an equivalent amount of DMSO vehicle. Data presented are the 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ean±SEM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f N=3 experiments. </a:t>
            </a: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B)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Effect conditioned media (CM) harvested from PC3 cells, cultured in the presence or absence 10µM 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nz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on </a:t>
            </a:r>
            <a:r>
              <a:rPr lang="en-US" sz="11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 vitro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ubule formation (TF) over 10 days. The number of junctions was measured using 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gioSys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2.0 software. Data presented are the 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ean±SEM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f N=8 fields of view. ns, not significant.</a:t>
            </a:r>
            <a:endParaRPr lang="en-GB" sz="11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58742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0"/>
          <p:cNvSpPr txBox="1"/>
          <p:nvPr/>
        </p:nvSpPr>
        <p:spPr>
          <a:xfrm>
            <a:off x="112350" y="645203"/>
            <a:ext cx="8624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(A)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3085760" y="643578"/>
            <a:ext cx="908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(B)</a:t>
            </a:r>
          </a:p>
        </p:txBody>
      </p:sp>
      <p:graphicFrame>
        <p:nvGraphicFramePr>
          <p:cNvPr id="44" name="Object 4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6199218"/>
              </p:ext>
            </p:extLst>
          </p:nvPr>
        </p:nvGraphicFramePr>
        <p:xfrm>
          <a:off x="316481" y="3192052"/>
          <a:ext cx="1979629" cy="21359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17" name="Prism 8" r:id="rId3" imgW="3027661" imgH="3270559" progId="Prism8.Document">
                  <p:embed/>
                </p:oleObj>
              </mc:Choice>
              <mc:Fallback>
                <p:oleObj name="Prism 8" r:id="rId3" imgW="3027661" imgH="3270559" progId="Prism8.Document">
                  <p:embed/>
                  <p:pic>
                    <p:nvPicPr>
                      <p:cNvPr id="44" name="Object 4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16481" y="3192052"/>
                        <a:ext cx="1979629" cy="213596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Object 4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36630077"/>
              </p:ext>
            </p:extLst>
          </p:nvPr>
        </p:nvGraphicFramePr>
        <p:xfrm>
          <a:off x="3303884" y="942886"/>
          <a:ext cx="1735138" cy="2041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18" name="Prism 5" r:id="rId5" imgW="2916379" imgH="3425785" progId="Prism5.Document">
                  <p:embed/>
                </p:oleObj>
              </mc:Choice>
              <mc:Fallback>
                <p:oleObj name="Prism 5" r:id="rId5" imgW="2916379" imgH="3425785" progId="Prism5.Document">
                  <p:embed/>
                  <p:pic>
                    <p:nvPicPr>
                      <p:cNvPr id="45" name="Object 4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03884" y="942886"/>
                        <a:ext cx="1735138" cy="20415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" name="Object 4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5502398"/>
              </p:ext>
            </p:extLst>
          </p:nvPr>
        </p:nvGraphicFramePr>
        <p:xfrm>
          <a:off x="5019675" y="905753"/>
          <a:ext cx="1838325" cy="2085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19" name="Prism 5" r:id="rId7" imgW="2753238" imgH="3362038" progId="Prism5.Document">
                  <p:embed/>
                </p:oleObj>
              </mc:Choice>
              <mc:Fallback>
                <p:oleObj name="Prism 5" r:id="rId7" imgW="2753238" imgH="3362038" progId="Prism5.Document">
                  <p:embed/>
                  <p:pic>
                    <p:nvPicPr>
                      <p:cNvPr id="46" name="Object 4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019675" y="905753"/>
                        <a:ext cx="1838325" cy="20859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47" name="TextBox 46"/>
          <p:cNvSpPr txBox="1"/>
          <p:nvPr/>
        </p:nvSpPr>
        <p:spPr>
          <a:xfrm>
            <a:off x="112350" y="3148031"/>
            <a:ext cx="908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(D)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3085760" y="3166363"/>
            <a:ext cx="908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(E)</a:t>
            </a:r>
          </a:p>
        </p:txBody>
      </p:sp>
      <p:graphicFrame>
        <p:nvGraphicFramePr>
          <p:cNvPr id="49" name="Object 4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2443645"/>
              </p:ext>
            </p:extLst>
          </p:nvPr>
        </p:nvGraphicFramePr>
        <p:xfrm>
          <a:off x="3472209" y="3224757"/>
          <a:ext cx="2405063" cy="22304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0" name="Prism 8" r:id="rId9" imgW="3567504" imgH="3302252" progId="Prism8.Document">
                  <p:embed/>
                </p:oleObj>
              </mc:Choice>
              <mc:Fallback>
                <p:oleObj name="Prism 8" r:id="rId9" imgW="3567504" imgH="3302252" progId="Prism8.Document">
                  <p:embed/>
                  <p:pic>
                    <p:nvPicPr>
                      <p:cNvPr id="49" name="Object 4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72209" y="3224757"/>
                        <a:ext cx="2405063" cy="22304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" name="Picture 1">
            <a:extLst>
              <a:ext uri="{FF2B5EF4-FFF2-40B4-BE49-F238E27FC236}">
                <a16:creationId xmlns:a16="http://schemas.microsoft.com/office/drawing/2014/main" id="{519EC6FF-092F-5644-A9FE-A3C62848055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97994" y="808540"/>
            <a:ext cx="2743200" cy="19050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BDEEABDD-6CCC-AF4E-BAEE-FE27448DD416}"/>
              </a:ext>
            </a:extLst>
          </p:cNvPr>
          <p:cNvSpPr txBox="1"/>
          <p:nvPr/>
        </p:nvSpPr>
        <p:spPr>
          <a:xfrm>
            <a:off x="15399" y="35496"/>
            <a:ext cx="24906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/>
              <a:t>SUPPLEMENTARY FIGURE 3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7E537948-1687-8B4C-880D-1C551F0738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CA5E5-DFF8-48DA-A404-FC1D15D82D9D}" type="slidenum">
              <a:rPr lang="en-GB" smtClean="0"/>
              <a:pPr/>
              <a:t>6</a:t>
            </a:fld>
            <a:endParaRPr lang="en-GB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3302A4F-EFC5-3541-8D24-8AF21198A3C9}"/>
              </a:ext>
            </a:extLst>
          </p:cNvPr>
          <p:cNvSpPr txBox="1"/>
          <p:nvPr/>
        </p:nvSpPr>
        <p:spPr>
          <a:xfrm>
            <a:off x="4803813" y="643578"/>
            <a:ext cx="908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(C)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5A2C5D7-C4FB-4046-A09B-CCD75BCADA7F}"/>
              </a:ext>
            </a:extLst>
          </p:cNvPr>
          <p:cNvSpPr/>
          <p:nvPr/>
        </p:nvSpPr>
        <p:spPr>
          <a:xfrm>
            <a:off x="188640" y="5484095"/>
            <a:ext cx="6408711" cy="24622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Hypoxia-promoted VEGF and IL-8 signaling effects on androgen receptor (AR) expression and activity and the response to Enzalutamide attenuated by VEGF/IL-8 </a:t>
            </a:r>
            <a:r>
              <a:rPr lang="en-US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nAbs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here relevant, cells were treated with 5mg/mL anti-IL-8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10mg/ml anti-VEGF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Control cells were treated with the highest concentration of isotype-matched human IgG antibody.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(A)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PCR analysis demonstrating up-regulation of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KLK3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PSA) mRNA expression in LNCaP and to a lesser extent in CWR-R1 cells, in response to hypoxia. Data shown are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ean±SE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N=4 experiments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B,C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ELISA data demonstrating the effect of administering anti-IL-8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/or anti-VEGF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n the hypoxia-induced secretion of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EGF and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L-8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 LNCaP cells. Data shown are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ean±SE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N=4 experiments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. (D)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PCR data demonstrating the effect of administering anti-IL-8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/or anti-VEGF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n the hypoxia (6h)-induced expression of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AR-full length (AR</a:t>
            </a:r>
            <a:r>
              <a:rPr lang="en-US" sz="11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KLK3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mRNA in LNCaP cells. Data shown are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ean±SE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N=3 experiments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E) 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fect of anti-IL-8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/or anti-VEGF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n viability of LNCaP and CWR-R1 cells under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ormoxi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hypoxic conditions. Statistical analysis was carried out using a Student’s t-test: *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&lt;0.05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**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&lt;0.0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Data shown are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ean±SE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N=3 individual experiments.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212454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/>
          <p:cNvGrpSpPr/>
          <p:nvPr/>
        </p:nvGrpSpPr>
        <p:grpSpPr>
          <a:xfrm>
            <a:off x="1340104" y="1008744"/>
            <a:ext cx="1835188" cy="2685413"/>
            <a:chOff x="-812920" y="1858538"/>
            <a:chExt cx="1835188" cy="2685413"/>
          </a:xfrm>
        </p:grpSpPr>
        <p:sp>
          <p:nvSpPr>
            <p:cNvPr id="24" name="Rectangle 23"/>
            <p:cNvSpPr/>
            <p:nvPr/>
          </p:nvSpPr>
          <p:spPr>
            <a:xfrm>
              <a:off x="-554448" y="2679795"/>
              <a:ext cx="748923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050" dirty="0"/>
                <a:t>VEGF </a:t>
              </a:r>
              <a:r>
                <a:rPr lang="en-GB" sz="1050" dirty="0" err="1"/>
                <a:t>nAb</a:t>
              </a:r>
              <a:endParaRPr lang="en-GB" sz="1050" dirty="0"/>
            </a:p>
          </p:txBody>
        </p:sp>
        <p:sp>
          <p:nvSpPr>
            <p:cNvPr id="29" name="Rectangle 28"/>
            <p:cNvSpPr/>
            <p:nvPr/>
          </p:nvSpPr>
          <p:spPr>
            <a:xfrm>
              <a:off x="-466837" y="3405793"/>
              <a:ext cx="635110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050" dirty="0"/>
                <a:t>IL-8 </a:t>
              </a:r>
              <a:r>
                <a:rPr lang="en-GB" sz="1050" dirty="0" err="1"/>
                <a:t>nAb</a:t>
              </a:r>
              <a:endParaRPr lang="en-GB" sz="1050" dirty="0"/>
            </a:p>
          </p:txBody>
        </p:sp>
        <p:sp>
          <p:nvSpPr>
            <p:cNvPr id="30" name="Rectangle 29"/>
            <p:cNvSpPr/>
            <p:nvPr/>
          </p:nvSpPr>
          <p:spPr>
            <a:xfrm>
              <a:off x="-286335" y="2019782"/>
              <a:ext cx="37542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050" dirty="0"/>
                <a:t>IgG</a:t>
              </a:r>
            </a:p>
          </p:txBody>
        </p:sp>
        <p:sp>
          <p:nvSpPr>
            <p:cNvPr id="31" name="Rectangle 30"/>
            <p:cNvSpPr/>
            <p:nvPr/>
          </p:nvSpPr>
          <p:spPr>
            <a:xfrm>
              <a:off x="-812920" y="4074232"/>
              <a:ext cx="976549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050" dirty="0"/>
                <a:t>VEGF/IL-8 </a:t>
              </a:r>
              <a:r>
                <a:rPr lang="en-GB" sz="1050" dirty="0" err="1"/>
                <a:t>nAb</a:t>
              </a:r>
              <a:endParaRPr lang="en-GB" sz="1050" dirty="0"/>
            </a:p>
          </p:txBody>
        </p:sp>
        <p:pic>
          <p:nvPicPr>
            <p:cNvPr id="32" name="Picture 3" descr="E:\IgG 4.tif"/>
            <p:cNvPicPr preferRelativeResize="0">
              <a:picLocks noChangeArrowheads="1"/>
            </p:cNvPicPr>
            <p:nvPr/>
          </p:nvPicPr>
          <p:blipFill>
            <a:blip r:embed="rId2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2977" y="1858538"/>
              <a:ext cx="896400" cy="6156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3" name="Picture 4" descr="E:\IL-8 nAb 2.tif"/>
            <p:cNvPicPr preferRelativeResize="0">
              <a:picLocks noChangeArrowheads="1"/>
            </p:cNvPicPr>
            <p:nvPr/>
          </p:nvPicPr>
          <p:blipFill>
            <a:blip r:embed="rId4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5868" y="3237676"/>
              <a:ext cx="896400" cy="6156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4" name="Picture 5" descr="E:\VEGF nAb 4tif.tif"/>
            <p:cNvPicPr preferRelativeResize="0">
              <a:picLocks noChangeArrowheads="1"/>
            </p:cNvPicPr>
            <p:nvPr/>
          </p:nvPicPr>
          <p:blipFill>
            <a:blip r:embed="rId6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2977" y="2547001"/>
              <a:ext cx="896400" cy="6156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5" name="Picture 6" descr="E:\VEGF + IL-8 nAb 1.tif"/>
            <p:cNvPicPr preferRelativeResize="0">
              <a:picLocks noChangeArrowheads="1"/>
            </p:cNvPicPr>
            <p:nvPr/>
          </p:nvPicPr>
          <p:blipFill>
            <a:blip r:embed="rId8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5868" y="3928351"/>
              <a:ext cx="896400" cy="6156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pic>
        <p:nvPicPr>
          <p:cNvPr id="2" name="Picture 1">
            <a:extLst>
              <a:ext uri="{FF2B5EF4-FFF2-40B4-BE49-F238E27FC236}">
                <a16:creationId xmlns:a16="http://schemas.microsoft.com/office/drawing/2014/main" id="{6B9D24DA-06D8-A643-B857-1B011C9390CC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b="11024"/>
          <a:stretch/>
        </p:blipFill>
        <p:spPr>
          <a:xfrm>
            <a:off x="3356992" y="831170"/>
            <a:ext cx="1828800" cy="2011383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230CEF2F-23B2-2248-8287-0F58F8DADCDF}"/>
              </a:ext>
            </a:extLst>
          </p:cNvPr>
          <p:cNvSpPr txBox="1"/>
          <p:nvPr/>
        </p:nvSpPr>
        <p:spPr>
          <a:xfrm>
            <a:off x="15399" y="35496"/>
            <a:ext cx="24906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/>
              <a:t>SUPPLEMENTARY FIGURE 4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D486FF18-8704-1E41-8884-370D98ECFC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CA5E5-DFF8-48DA-A404-FC1D15D82D9D}" type="slidenum">
              <a:rPr lang="en-GB" smtClean="0"/>
              <a:pPr/>
              <a:t>7</a:t>
            </a:fld>
            <a:endParaRPr lang="en-GB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981C77BF-35D4-3547-B824-D8BB0E7EA5D4}"/>
              </a:ext>
            </a:extLst>
          </p:cNvPr>
          <p:cNvSpPr/>
          <p:nvPr/>
        </p:nvSpPr>
        <p:spPr>
          <a:xfrm>
            <a:off x="193464" y="4199865"/>
            <a:ext cx="6321636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.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L-8 and VEGF neutralizing antibodies do not attenuate the 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in vitro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vessel formation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epresentative images and bar graph demonstrating the effect of 5mg/ml anti-IL-8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/or 10mg/ml anti-VEGF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n HUVEC tubule formation (TF) over 10 days. The number of junctions was measured using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AngioSy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2.0 software. Data presented are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ean±SE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N=8 fields of view.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134824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5367064" y="618711"/>
            <a:ext cx="1145691" cy="1320348"/>
            <a:chOff x="5021158" y="179512"/>
            <a:chExt cx="1145691" cy="1320348"/>
          </a:xfrm>
        </p:grpSpPr>
        <p:grpSp>
          <p:nvGrpSpPr>
            <p:cNvPr id="7" name="Group 6"/>
            <p:cNvGrpSpPr/>
            <p:nvPr/>
          </p:nvGrpSpPr>
          <p:grpSpPr>
            <a:xfrm>
              <a:off x="5022764" y="179512"/>
              <a:ext cx="1144085" cy="1320348"/>
              <a:chOff x="5022764" y="179512"/>
              <a:chExt cx="1144085" cy="1320348"/>
            </a:xfrm>
          </p:grpSpPr>
          <p:grpSp>
            <p:nvGrpSpPr>
              <p:cNvPr id="9" name="Group 8"/>
              <p:cNvGrpSpPr/>
              <p:nvPr/>
            </p:nvGrpSpPr>
            <p:grpSpPr>
              <a:xfrm>
                <a:off x="5022764" y="179512"/>
                <a:ext cx="1144085" cy="1320348"/>
                <a:chOff x="1848672" y="4932040"/>
                <a:chExt cx="1144085" cy="1320348"/>
              </a:xfrm>
            </p:grpSpPr>
            <p:sp>
              <p:nvSpPr>
                <p:cNvPr id="11" name="TextBox 10"/>
                <p:cNvSpPr txBox="1"/>
                <p:nvPr/>
              </p:nvSpPr>
              <p:spPr>
                <a:xfrm rot="16200000">
                  <a:off x="1598764" y="5277083"/>
                  <a:ext cx="753732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50" dirty="0" err="1"/>
                    <a:t>LNCaP</a:t>
                  </a:r>
                  <a:r>
                    <a:rPr lang="en-GB" sz="1050" dirty="0"/>
                    <a:t>-Par</a:t>
                  </a: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 rot="16200000">
                  <a:off x="1890703" y="5235810"/>
                  <a:ext cx="869149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50" dirty="0"/>
                    <a:t>LNCaP-</a:t>
                  </a:r>
                  <a:r>
                    <a:rPr lang="en-GB" sz="1050" dirty="0" err="1"/>
                    <a:t>EnzR</a:t>
                  </a:r>
                  <a:endParaRPr lang="en-GB" sz="1050" dirty="0"/>
                </a:p>
              </p:txBody>
            </p:sp>
            <p:pic>
              <p:nvPicPr>
                <p:cNvPr id="13" name="Picture 2" descr="C:\Users\Pamela Maxwell\AppData\Local\Microsoft\Windows\Temporary Internet Files\Content.Outlook\D1LLECEB\EnzR+ Enz + nAbs  AR 1.tif"/>
                <p:cNvPicPr>
                  <a:picLocks noChangeAspect="1" noChangeArrowheads="1"/>
                </p:cNvPicPr>
                <p:nvPr/>
              </p:nvPicPr>
              <p:blipFill rotWithShape="1">
                <a:blip r:embed="rId3" cstate="print">
                  <a:grayscl/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brightnessContrast bright="2000" contrast="-3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 l="59719" t="49654" r="28781" b="44644"/>
                <a:stretch/>
              </p:blipFill>
              <p:spPr bwMode="auto">
                <a:xfrm flipH="1">
                  <a:off x="1875641" y="5729490"/>
                  <a:ext cx="565625" cy="171921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4" name="TextBox 13"/>
                <p:cNvSpPr txBox="1"/>
                <p:nvPr/>
              </p:nvSpPr>
              <p:spPr>
                <a:xfrm>
                  <a:off x="2408943" y="5676070"/>
                  <a:ext cx="336952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50" dirty="0"/>
                    <a:t>AR</a:t>
                  </a: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2408943" y="5998472"/>
                  <a:ext cx="583814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50" dirty="0">
                      <a:cs typeface="Arial" panose="020B0604020202020204" pitchFamily="34" charset="0"/>
                    </a:rPr>
                    <a:t>GAPDH</a:t>
                  </a:r>
                </a:p>
              </p:txBody>
            </p:sp>
          </p:grpSp>
          <p:pic>
            <p:nvPicPr>
              <p:cNvPr id="10" name="Picture 4" descr="C:\Users\Pamela Maxwell\AppData\Local\Microsoft\Windows\Temporary Internet Files\Content.Outlook\D1LLECEB\EnzR + Enz + nAbs  beta-tubulin (FLIP blot) 1.tif"/>
              <p:cNvPicPr preferRelativeResize="0">
                <a:picLocks noChangeArrowheads="1"/>
              </p:cNvPicPr>
              <p:nvPr/>
            </p:nvPicPr>
            <p:blipFill rotWithShape="1">
              <a:blip r:embed="rId5" cstate="print">
                <a:grayscl/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39180" t="8705" r="47632" b="83853"/>
              <a:stretch/>
            </p:blipFill>
            <p:spPr bwMode="auto">
              <a:xfrm flipH="1">
                <a:off x="5056609" y="1291239"/>
                <a:ext cx="565200" cy="1728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8" name="TextBox 7"/>
            <p:cNvSpPr txBox="1"/>
            <p:nvPr/>
          </p:nvSpPr>
          <p:spPr>
            <a:xfrm>
              <a:off x="5021158" y="1098291"/>
              <a:ext cx="6415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/>
                <a:t>1.0       2.25  </a:t>
              </a:r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5388991" y="1891050"/>
            <a:ext cx="1174179" cy="1622068"/>
            <a:chOff x="3766989" y="116796"/>
            <a:chExt cx="1174179" cy="1622068"/>
          </a:xfrm>
        </p:grpSpPr>
        <p:grpSp>
          <p:nvGrpSpPr>
            <p:cNvPr id="17" name="Group 16"/>
            <p:cNvGrpSpPr/>
            <p:nvPr/>
          </p:nvGrpSpPr>
          <p:grpSpPr>
            <a:xfrm>
              <a:off x="3777709" y="116796"/>
              <a:ext cx="1163459" cy="1622068"/>
              <a:chOff x="6005181" y="519822"/>
              <a:chExt cx="1163459" cy="1622068"/>
            </a:xfrm>
          </p:grpSpPr>
          <p:pic>
            <p:nvPicPr>
              <p:cNvPr id="20" name="Picture 3" descr="C:\Users\Pamela Maxwell\AppData\Local\Microsoft\Windows\Temporary Internet Files\Content.Outlook\D1LLECEB\22rv1-r1-enzR_ARv7 (3).tif"/>
              <p:cNvPicPr preferRelativeResize="0">
                <a:picLocks noChangeArrowheads="1"/>
              </p:cNvPicPr>
              <p:nvPr/>
            </p:nvPicPr>
            <p:blipFill rotWithShape="1">
              <a:blip r:embed="rId6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3000" contrast="-47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4835" t="40421" r="47321" b="56210"/>
              <a:stretch/>
            </p:blipFill>
            <p:spPr bwMode="auto">
              <a:xfrm flipH="1">
                <a:off x="6005181" y="1651678"/>
                <a:ext cx="565200" cy="172800"/>
              </a:xfrm>
              <a:prstGeom prst="rect">
                <a:avLst/>
              </a:prstGeom>
              <a:noFill/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1" name="TextBox 20"/>
              <p:cNvSpPr txBox="1"/>
              <p:nvPr/>
            </p:nvSpPr>
            <p:spPr>
              <a:xfrm rot="16200000">
                <a:off x="5740924" y="884239"/>
                <a:ext cx="814647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50" dirty="0"/>
                  <a:t>CWRR1-Par</a:t>
                </a:r>
                <a:endParaRPr lang="en-US" sz="1050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 rot="16200000">
                <a:off x="6045026" y="841866"/>
                <a:ext cx="898003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50" dirty="0"/>
                  <a:t>CWRR1-EnzR</a:t>
                </a:r>
                <a:endParaRPr lang="en-US" sz="1050" dirty="0"/>
              </a:p>
            </p:txBody>
          </p:sp>
          <p:pic>
            <p:nvPicPr>
              <p:cNvPr id="23" name="Picture 4" descr="\\143.117.137.154\NetworkShare\1st Floor\judi\feb 18\22rv1 and r1 -par-enzR _ panel\22rv1-r1-enzR_ARov.tif"/>
              <p:cNvPicPr preferRelativeResize="0">
                <a:picLocks noChangeArrowheads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4385" t="59228" r="47021" b="36612"/>
              <a:stretch/>
            </p:blipFill>
            <p:spPr bwMode="auto">
              <a:xfrm flipH="1">
                <a:off x="6005181" y="1369948"/>
                <a:ext cx="565200" cy="172800"/>
              </a:xfrm>
              <a:prstGeom prst="rect">
                <a:avLst/>
              </a:prstGeom>
              <a:noFill/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4" name="Picture 5" descr="\\143.117.137.154\NetworkShare\1st Floor\judi\feb 18\22rv1 and r1 -par-enzR _ panel\22rv1-r1-enzR_GAPDH.tif"/>
              <p:cNvPicPr preferRelativeResize="0">
                <a:picLocks noChangeArrowheads="1"/>
              </p:cNvPicPr>
              <p:nvPr/>
            </p:nvPicPr>
            <p:blipFill rotWithShape="1">
              <a:blip r:embed="rId9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509" t="30175" r="58467" b="65755"/>
              <a:stretch/>
            </p:blipFill>
            <p:spPr bwMode="auto">
              <a:xfrm flipH="1">
                <a:off x="6005181" y="1929358"/>
                <a:ext cx="565200" cy="172800"/>
              </a:xfrm>
              <a:prstGeom prst="rect">
                <a:avLst/>
              </a:prstGeom>
              <a:noFill/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5" name="TextBox 24"/>
              <p:cNvSpPr txBox="1"/>
              <p:nvPr/>
            </p:nvSpPr>
            <p:spPr>
              <a:xfrm>
                <a:off x="6597352" y="1317070"/>
                <a:ext cx="33695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50" dirty="0"/>
                  <a:t>AR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6584826" y="1887974"/>
                <a:ext cx="58381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50" dirty="0">
                    <a:cs typeface="Arial" panose="020B0604020202020204" pitchFamily="34" charset="0"/>
                  </a:rPr>
                  <a:t>GAPDH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6584826" y="1599942"/>
                <a:ext cx="46679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50" dirty="0"/>
                  <a:t>ARv7</a:t>
                </a:r>
              </a:p>
            </p:txBody>
          </p:sp>
        </p:grpSp>
        <p:sp>
          <p:nvSpPr>
            <p:cNvPr id="18" name="TextBox 17"/>
            <p:cNvSpPr txBox="1"/>
            <p:nvPr/>
          </p:nvSpPr>
          <p:spPr>
            <a:xfrm>
              <a:off x="3783064" y="1087363"/>
              <a:ext cx="6415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/>
                <a:t>1.0       0.38  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766989" y="1378476"/>
              <a:ext cx="6415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/>
                <a:t>1.0       1.90  </a:t>
              </a:r>
            </a:p>
          </p:txBody>
        </p:sp>
      </p:grpSp>
      <p:sp>
        <p:nvSpPr>
          <p:cNvPr id="33" name="TextBox 32"/>
          <p:cNvSpPr txBox="1"/>
          <p:nvPr/>
        </p:nvSpPr>
        <p:spPr>
          <a:xfrm>
            <a:off x="105876" y="618711"/>
            <a:ext cx="908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(A)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2232248" y="618711"/>
            <a:ext cx="908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(B)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4797152" y="614098"/>
            <a:ext cx="908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(C)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111208" y="3777095"/>
            <a:ext cx="908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(D)</a:t>
            </a:r>
          </a:p>
        </p:txBody>
      </p:sp>
      <p:graphicFrame>
        <p:nvGraphicFramePr>
          <p:cNvPr id="37" name="Object 3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5431444"/>
              </p:ext>
            </p:extLst>
          </p:nvPr>
        </p:nvGraphicFramePr>
        <p:xfrm>
          <a:off x="565219" y="3783929"/>
          <a:ext cx="1216025" cy="1790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41" name="Prism 8" r:id="rId11" imgW="1994071" imgH="2933455" progId="Prism8.Document">
                  <p:embed/>
                </p:oleObj>
              </mc:Choice>
              <mc:Fallback>
                <p:oleObj name="Prism 8" r:id="rId11" imgW="1994071" imgH="2933455" progId="Prism8.Document">
                  <p:embed/>
                  <p:pic>
                    <p:nvPicPr>
                      <p:cNvPr id="37" name="Object 3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65219" y="3783929"/>
                        <a:ext cx="1216025" cy="17907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Object 3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0856516"/>
              </p:ext>
            </p:extLst>
          </p:nvPr>
        </p:nvGraphicFramePr>
        <p:xfrm>
          <a:off x="1834341" y="3754673"/>
          <a:ext cx="1216025" cy="1790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42" name="Prism 8" r:id="rId13" imgW="1994071" imgH="2933455" progId="Prism8.Document">
                  <p:embed/>
                </p:oleObj>
              </mc:Choice>
              <mc:Fallback>
                <p:oleObj name="Prism 8" r:id="rId13" imgW="1994071" imgH="2933455" progId="Prism8.Document">
                  <p:embed/>
                  <p:pic>
                    <p:nvPicPr>
                      <p:cNvPr id="38" name="Object 3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834341" y="3754673"/>
                        <a:ext cx="1216025" cy="17907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" name="TextBox 38"/>
          <p:cNvSpPr txBox="1"/>
          <p:nvPr/>
        </p:nvSpPr>
        <p:spPr>
          <a:xfrm>
            <a:off x="3140968" y="3783929"/>
            <a:ext cx="908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(E)</a:t>
            </a:r>
          </a:p>
        </p:txBody>
      </p:sp>
      <p:graphicFrame>
        <p:nvGraphicFramePr>
          <p:cNvPr id="40" name="Object 3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04431804"/>
              </p:ext>
            </p:extLst>
          </p:nvPr>
        </p:nvGraphicFramePr>
        <p:xfrm>
          <a:off x="3633738" y="3777095"/>
          <a:ext cx="1197308" cy="17178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43" name="Prism 5" r:id="rId15" imgW="1965261" imgH="2817485" progId="Prism5.Document">
                  <p:embed/>
                </p:oleObj>
              </mc:Choice>
              <mc:Fallback>
                <p:oleObj name="Prism 5" r:id="rId15" imgW="1965261" imgH="2817485" progId="Prism5.Document">
                  <p:embed/>
                  <p:pic>
                    <p:nvPicPr>
                      <p:cNvPr id="40" name="Object 3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33738" y="3777095"/>
                        <a:ext cx="1197308" cy="171787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" name="Object 4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15804772"/>
              </p:ext>
            </p:extLst>
          </p:nvPr>
        </p:nvGraphicFramePr>
        <p:xfrm>
          <a:off x="4759554" y="3824067"/>
          <a:ext cx="1272170" cy="16692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44" name="Prism 5" r:id="rId17" imgW="2069280" imgH="2711160" progId="Prism5.Document">
                  <p:embed/>
                </p:oleObj>
              </mc:Choice>
              <mc:Fallback>
                <p:oleObj name="Prism 5" r:id="rId17" imgW="2069280" imgH="2711160" progId="Prism5.Document">
                  <p:embed/>
                  <p:pic>
                    <p:nvPicPr>
                      <p:cNvPr id="41" name="Object 4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759554" y="3824067"/>
                        <a:ext cx="1272170" cy="166927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" name="Picture 1">
            <a:extLst>
              <a:ext uri="{FF2B5EF4-FFF2-40B4-BE49-F238E27FC236}">
                <a16:creationId xmlns:a16="http://schemas.microsoft.com/office/drawing/2014/main" id="{BCBB02E5-1E22-CC46-858E-0ADE6ECC193D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b="9731"/>
          <a:stretch/>
        </p:blipFill>
        <p:spPr>
          <a:xfrm>
            <a:off x="321962" y="797709"/>
            <a:ext cx="1854200" cy="2373083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7D68F9EA-17AA-0841-90E1-5A8B9704AAF5}"/>
              </a:ext>
            </a:extLst>
          </p:cNvPr>
          <p:cNvSpPr txBox="1"/>
          <p:nvPr/>
        </p:nvSpPr>
        <p:spPr>
          <a:xfrm>
            <a:off x="15399" y="35496"/>
            <a:ext cx="24906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/>
              <a:t>SUPPLEMENTARY FIGURE 5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52AFA4EB-2AEA-B440-92A1-5E50784FF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CA5E5-DFF8-48DA-A404-FC1D15D82D9D}" type="slidenum">
              <a:rPr lang="en-GB" smtClean="0"/>
              <a:pPr/>
              <a:t>8</a:t>
            </a:fld>
            <a:endParaRPr lang="en-GB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7A6B98E7-86D0-FC49-AB1C-09B85CD87138}"/>
              </a:ext>
            </a:extLst>
          </p:cNvPr>
          <p:cNvSpPr/>
          <p:nvPr/>
        </p:nvSpPr>
        <p:spPr>
          <a:xfrm>
            <a:off x="467728" y="2543358"/>
            <a:ext cx="1590438" cy="6941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E2D472A-0B55-AA4F-B25C-7EFDA91013AB}"/>
              </a:ext>
            </a:extLst>
          </p:cNvPr>
          <p:cNvSpPr txBox="1"/>
          <p:nvPr/>
        </p:nvSpPr>
        <p:spPr>
          <a:xfrm rot="18892042">
            <a:off x="869874" y="2526947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r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E0A24C4-849F-D44B-ABB5-C4BEE3B8EC00}"/>
              </a:ext>
            </a:extLst>
          </p:cNvPr>
          <p:cNvSpPr txBox="1"/>
          <p:nvPr/>
        </p:nvSpPr>
        <p:spPr>
          <a:xfrm rot="18892042">
            <a:off x="1319408" y="2526947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r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E8B4ECEF-A310-7741-8CEE-F8C0189FBB81}"/>
              </a:ext>
            </a:extLst>
          </p:cNvPr>
          <p:cNvSpPr txBox="1"/>
          <p:nvPr/>
        </p:nvSpPr>
        <p:spPr>
          <a:xfrm rot="18892042">
            <a:off x="994312" y="2560895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EnzR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DF9B4DB-7D4F-F24C-A62D-EC19BD8A3E84}"/>
              </a:ext>
            </a:extLst>
          </p:cNvPr>
          <p:cNvSpPr txBox="1"/>
          <p:nvPr/>
        </p:nvSpPr>
        <p:spPr>
          <a:xfrm rot="18892042">
            <a:off x="1498368" y="2544904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EnzR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1503A9F0-2FF5-2B48-AD7A-B55C5EB871B7}"/>
              </a:ext>
            </a:extLst>
          </p:cNvPr>
          <p:cNvCxnSpPr/>
          <p:nvPr/>
        </p:nvCxnSpPr>
        <p:spPr>
          <a:xfrm flipV="1">
            <a:off x="872469" y="2898371"/>
            <a:ext cx="531612" cy="105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1C9B75FD-A1B4-E042-972E-B5F0AC82F152}"/>
              </a:ext>
            </a:extLst>
          </p:cNvPr>
          <p:cNvCxnSpPr/>
          <p:nvPr/>
        </p:nvCxnSpPr>
        <p:spPr>
          <a:xfrm flipV="1">
            <a:off x="1483687" y="2884452"/>
            <a:ext cx="531612" cy="105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6192527-ABBA-514F-90B4-20954DD633DB}"/>
              </a:ext>
            </a:extLst>
          </p:cNvPr>
          <p:cNvSpPr txBox="1"/>
          <p:nvPr/>
        </p:nvSpPr>
        <p:spPr>
          <a:xfrm>
            <a:off x="857518" y="2879145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03031F6E-24B2-AD4D-BCA8-371DF637ECF7}"/>
              </a:ext>
            </a:extLst>
          </p:cNvPr>
          <p:cNvSpPr txBox="1"/>
          <p:nvPr/>
        </p:nvSpPr>
        <p:spPr>
          <a:xfrm>
            <a:off x="1425705" y="2866964"/>
            <a:ext cx="6559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WRR1</a:t>
            </a: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8EAA716B-946D-CF46-8047-5FBA367D8D7A}"/>
              </a:ext>
            </a:extLst>
          </p:cNvPr>
          <p:cNvSpPr/>
          <p:nvPr/>
        </p:nvSpPr>
        <p:spPr>
          <a:xfrm>
            <a:off x="668202" y="5116323"/>
            <a:ext cx="1252742" cy="5618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66945E3B-00A4-1346-848B-709998D3BEA4}"/>
              </a:ext>
            </a:extLst>
          </p:cNvPr>
          <p:cNvSpPr/>
          <p:nvPr/>
        </p:nvSpPr>
        <p:spPr>
          <a:xfrm>
            <a:off x="1764708" y="5105471"/>
            <a:ext cx="1252742" cy="5618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1AED8E34-E45A-BA42-BD6F-93377CA53118}"/>
              </a:ext>
            </a:extLst>
          </p:cNvPr>
          <p:cNvSpPr txBox="1"/>
          <p:nvPr/>
        </p:nvSpPr>
        <p:spPr>
          <a:xfrm rot="18892042">
            <a:off x="1219910" y="5107173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EnzR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15845F4-5F5F-A247-935F-E89D29E83E4A}"/>
              </a:ext>
            </a:extLst>
          </p:cNvPr>
          <p:cNvSpPr txBox="1"/>
          <p:nvPr/>
        </p:nvSpPr>
        <p:spPr>
          <a:xfrm rot="18892042">
            <a:off x="2520226" y="5077917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EnzR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8FFF32B-1083-684F-9FCC-A4C9947850DD}"/>
              </a:ext>
            </a:extLst>
          </p:cNvPr>
          <p:cNvSpPr txBox="1"/>
          <p:nvPr/>
        </p:nvSpPr>
        <p:spPr>
          <a:xfrm rot="18892042">
            <a:off x="884915" y="5066841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r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0ED0551-279F-7F4C-B726-AB2F290751F8}"/>
              </a:ext>
            </a:extLst>
          </p:cNvPr>
          <p:cNvSpPr txBox="1"/>
          <p:nvPr/>
        </p:nvSpPr>
        <p:spPr>
          <a:xfrm rot="18892042">
            <a:off x="2163983" y="5037585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r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88A4C905-A3B8-1F4E-9174-B565CBDE0429}"/>
              </a:ext>
            </a:extLst>
          </p:cNvPr>
          <p:cNvSpPr txBox="1"/>
          <p:nvPr/>
        </p:nvSpPr>
        <p:spPr>
          <a:xfrm>
            <a:off x="915371" y="5431968"/>
            <a:ext cx="6718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VCaP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A684B753-799C-EA4C-9617-FF746736A3F3}"/>
              </a:ext>
            </a:extLst>
          </p:cNvPr>
          <p:cNvSpPr txBox="1"/>
          <p:nvPr/>
        </p:nvSpPr>
        <p:spPr>
          <a:xfrm>
            <a:off x="2143446" y="5411824"/>
            <a:ext cx="725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VCaP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BA3D8994-04A9-A543-A650-B381BD069633}"/>
              </a:ext>
            </a:extLst>
          </p:cNvPr>
          <p:cNvCxnSpPr>
            <a:cxnSpLocks/>
          </p:cNvCxnSpPr>
          <p:nvPr/>
        </p:nvCxnSpPr>
        <p:spPr>
          <a:xfrm>
            <a:off x="915371" y="5431968"/>
            <a:ext cx="725507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38ECC5F4-18D5-3F45-A48C-8AAC4126FBBE}"/>
              </a:ext>
            </a:extLst>
          </p:cNvPr>
          <p:cNvCxnSpPr>
            <a:cxnSpLocks/>
          </p:cNvCxnSpPr>
          <p:nvPr/>
        </p:nvCxnSpPr>
        <p:spPr>
          <a:xfrm>
            <a:off x="2143446" y="5402270"/>
            <a:ext cx="725507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Rectangle 62">
            <a:extLst>
              <a:ext uri="{FF2B5EF4-FFF2-40B4-BE49-F238E27FC236}">
                <a16:creationId xmlns:a16="http://schemas.microsoft.com/office/drawing/2014/main" id="{706B41F7-9DE0-5145-BC4E-05B5ADD77BCA}"/>
              </a:ext>
            </a:extLst>
          </p:cNvPr>
          <p:cNvSpPr/>
          <p:nvPr/>
        </p:nvSpPr>
        <p:spPr>
          <a:xfrm>
            <a:off x="5381468" y="519316"/>
            <a:ext cx="802996" cy="88219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693DA9F8-0239-F841-8A96-8906CA3E4B6B}"/>
              </a:ext>
            </a:extLst>
          </p:cNvPr>
          <p:cNvSpPr/>
          <p:nvPr/>
        </p:nvSpPr>
        <p:spPr>
          <a:xfrm>
            <a:off x="5375278" y="1983480"/>
            <a:ext cx="802996" cy="72251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4AA15252-9C9B-9B4E-896C-EBE39B8E45AE}"/>
              </a:ext>
            </a:extLst>
          </p:cNvPr>
          <p:cNvSpPr txBox="1"/>
          <p:nvPr/>
        </p:nvSpPr>
        <p:spPr>
          <a:xfrm rot="16200000">
            <a:off x="5351886" y="1155479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r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FE6F4043-953C-8341-808C-C52B9AE660A3}"/>
              </a:ext>
            </a:extLst>
          </p:cNvPr>
          <p:cNvSpPr txBox="1"/>
          <p:nvPr/>
        </p:nvSpPr>
        <p:spPr>
          <a:xfrm rot="16200000">
            <a:off x="5354098" y="2471018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r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27281F1F-2FE4-DE44-AF7A-D190CEFB7913}"/>
              </a:ext>
            </a:extLst>
          </p:cNvPr>
          <p:cNvSpPr txBox="1"/>
          <p:nvPr/>
        </p:nvSpPr>
        <p:spPr>
          <a:xfrm rot="16200000">
            <a:off x="5514209" y="1094975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EnzR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AC541209-26FF-D24B-993B-0B19357F3946}"/>
              </a:ext>
            </a:extLst>
          </p:cNvPr>
          <p:cNvSpPr txBox="1"/>
          <p:nvPr/>
        </p:nvSpPr>
        <p:spPr>
          <a:xfrm rot="16200000">
            <a:off x="5574214" y="2411949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EnzR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644BD24B-70AC-B849-920E-6363BCBD5041}"/>
              </a:ext>
            </a:extLst>
          </p:cNvPr>
          <p:cNvCxnSpPr>
            <a:cxnSpLocks/>
          </p:cNvCxnSpPr>
          <p:nvPr/>
        </p:nvCxnSpPr>
        <p:spPr>
          <a:xfrm>
            <a:off x="5395639" y="984682"/>
            <a:ext cx="597446" cy="38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41EB884C-DE84-804E-98A7-29F99D93AB5B}"/>
              </a:ext>
            </a:extLst>
          </p:cNvPr>
          <p:cNvCxnSpPr>
            <a:cxnSpLocks/>
          </p:cNvCxnSpPr>
          <p:nvPr/>
        </p:nvCxnSpPr>
        <p:spPr>
          <a:xfrm>
            <a:off x="5380725" y="2316326"/>
            <a:ext cx="597446" cy="38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973D00E7-78F7-F949-B579-8A6E937AB15A}"/>
              </a:ext>
            </a:extLst>
          </p:cNvPr>
          <p:cNvSpPr txBox="1"/>
          <p:nvPr/>
        </p:nvSpPr>
        <p:spPr>
          <a:xfrm>
            <a:off x="5375731" y="746702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7D50DC78-4269-714A-91F9-D80BC122F0FF}"/>
              </a:ext>
            </a:extLst>
          </p:cNvPr>
          <p:cNvSpPr txBox="1"/>
          <p:nvPr/>
        </p:nvSpPr>
        <p:spPr>
          <a:xfrm>
            <a:off x="5352656" y="2092538"/>
            <a:ext cx="6559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WRR1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AF1FC548-22ED-1E42-A4E7-1B8007E15920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b="9924"/>
          <a:stretch/>
        </p:blipFill>
        <p:spPr>
          <a:xfrm>
            <a:off x="2420888" y="724451"/>
            <a:ext cx="2425700" cy="2413769"/>
          </a:xfrm>
          <a:prstGeom prst="rect">
            <a:avLst/>
          </a:prstGeom>
        </p:spPr>
      </p:pic>
      <p:sp>
        <p:nvSpPr>
          <p:cNvPr id="76" name="Rectangle 75">
            <a:extLst>
              <a:ext uri="{FF2B5EF4-FFF2-40B4-BE49-F238E27FC236}">
                <a16:creationId xmlns:a16="http://schemas.microsoft.com/office/drawing/2014/main" id="{7C03D749-EFE2-144A-976E-9D84B8669909}"/>
              </a:ext>
            </a:extLst>
          </p:cNvPr>
          <p:cNvSpPr/>
          <p:nvPr/>
        </p:nvSpPr>
        <p:spPr>
          <a:xfrm>
            <a:off x="268182" y="5708965"/>
            <a:ext cx="6321636" cy="280076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haracterization of Enzalutamide-resistance (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EnzR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) in LNCaP, CWR-R1 and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VCaP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prostate cancer cells. (A) 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fect of 10µM Enzalutamide 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Enz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on viability of LNCaP-Parental (Par), LNCaP-Enzalutamide-resistant 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Enz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, CWRR1-Par and CWRR1-EnzR cells. Control cells were treated with an equivalent volume of DMSO. Data shown are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ean±SE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N=3 experiments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qPCR data demonstrating AR-full length (AR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 AR-V7 mRNA expression in LNCaP-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Enz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CWRR1-EnzR cells relative to corresponding parental cells. Data shown are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ean±SE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N=3 experiments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mmunoblots demonstrating altered AR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FL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/or AR-V7 expression by LNCaP-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Enz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CWRR1-EnzR cells relative to corresponding parental cells. Equal loading was assessed using GAPDH. Relative expression was determined by densitometry using Image J software. Blots shown are representative of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ean±SE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N=3 experiments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alysis of publicly-available data sets (GSE78201) demonstrating increased mRNA expression of VEGF and IL-8 in VCAP-Par and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Enz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cells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E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NA-sequencing analysis of Enzalutamide-sensitive versus Enzalutamide-resistant, LNCaP-derived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in vivo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odels. Data shown illustrates the mRNA levels of VEGF and IL-8 in Enzalutamide-sensitive line V16 versus two Enzalutamide-resistant lines, MR49F and MR49C. For all data, statistically significant differences were determined using a Student’s two-tailed t-test or Mann-Whitney U test: *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&lt;0.05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**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&lt;0.01.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017857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62764D3-6845-E046-9CD3-5820F00453C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0075"/>
          <a:stretch/>
        </p:blipFill>
        <p:spPr>
          <a:xfrm>
            <a:off x="2060848" y="757210"/>
            <a:ext cx="2184400" cy="214704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467F28C-C10B-9F47-BC1E-26C3267A059A}"/>
              </a:ext>
            </a:extLst>
          </p:cNvPr>
          <p:cNvSpPr txBox="1"/>
          <p:nvPr/>
        </p:nvSpPr>
        <p:spPr>
          <a:xfrm>
            <a:off x="15399" y="35496"/>
            <a:ext cx="24906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/>
              <a:t>SUPPLEMENTARY FIGURE 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E133F16-233D-46CE-B4CC-F59399ABA5BC}"/>
              </a:ext>
            </a:extLst>
          </p:cNvPr>
          <p:cNvSpPr txBox="1"/>
          <p:nvPr/>
        </p:nvSpPr>
        <p:spPr>
          <a:xfrm>
            <a:off x="139558" y="3042752"/>
            <a:ext cx="6385786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. </a:t>
            </a:r>
            <a:r>
              <a:rPr lang="en-GB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IL-8 and VEGF neutralizing antibodies in combination with Enzalutamide decreased viability of LNCaP-</a:t>
            </a:r>
            <a:r>
              <a:rPr lang="en-GB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EnzR</a:t>
            </a:r>
            <a:r>
              <a:rPr lang="en-GB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 cells.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Where appropriate, cells were treated with 5mg/mL anti-IL-8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and 10mg/ml anti-VEGF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. Control cells were treated with the highest concentration of isotype-matched human IgG antibody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ffect of administering anti-IL-8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/or anti-VEGF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n viability of LNCaP-Par cells treated with10µM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Enz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Control cells were treated with an equivalent amount of DMSO.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ata shown are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ean±SE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N=3 experiments. 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14882343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8604D7B002F574999187FF4BC785067" ma:contentTypeVersion="12" ma:contentTypeDescription="Create a new document." ma:contentTypeScope="" ma:versionID="d0305bfab575612499275e926ffb0c51">
  <xsd:schema xmlns:xsd="http://www.w3.org/2001/XMLSchema" xmlns:xs="http://www.w3.org/2001/XMLSchema" xmlns:p="http://schemas.microsoft.com/office/2006/metadata/properties" xmlns:ns3="4958b441-58fb-4e9f-b79b-5199dcd2f3a7" xmlns:ns4="8d7a6499-3b1c-4e44-8066-661fbf4f9fc5" targetNamespace="http://schemas.microsoft.com/office/2006/metadata/properties" ma:root="true" ma:fieldsID="0e1a05f4228b31d26d4d78d7d4e774a0" ns3:_="" ns4:_="">
    <xsd:import namespace="4958b441-58fb-4e9f-b79b-5199dcd2f3a7"/>
    <xsd:import namespace="8d7a6499-3b1c-4e44-8066-661fbf4f9fc5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958b441-58fb-4e9f-b79b-5199dcd2f3a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d7a6499-3b1c-4e44-8066-661fbf4f9fc5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B3B7D099-DF99-470B-AFD9-C94A4A50AC55}">
  <ds:schemaRefs>
    <ds:schemaRef ds:uri="4958b441-58fb-4e9f-b79b-5199dcd2f3a7"/>
    <ds:schemaRef ds:uri="http://schemas.microsoft.com/office/2006/documentManagement/types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8d7a6499-3b1c-4e44-8066-661fbf4f9fc5"/>
    <ds:schemaRef ds:uri="http://purl.org/dc/elements/1.1/"/>
    <ds:schemaRef ds:uri="http://schemas.microsoft.com/office/2006/metadata/properties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CCA6A01E-5791-4A14-AC50-DFF143C3A35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958b441-58fb-4e9f-b79b-5199dcd2f3a7"/>
    <ds:schemaRef ds:uri="8d7a6499-3b1c-4e44-8066-661fbf4f9fc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A9C8B971-D8EA-4FB4-9FAB-B69E5143845E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97973</TotalTime>
  <Words>1924</Words>
  <Application>Microsoft Office PowerPoint</Application>
  <PresentationFormat>On-screen Show (4:3)</PresentationFormat>
  <Paragraphs>186</Paragraphs>
  <Slides>1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1</vt:i4>
      </vt:variant>
    </vt:vector>
  </HeadingPairs>
  <TitlesOfParts>
    <vt:vector size="17" baseType="lpstr">
      <vt:lpstr>Arial</vt:lpstr>
      <vt:lpstr>Calibri</vt:lpstr>
      <vt:lpstr>Times New Roman</vt:lpstr>
      <vt:lpstr>Office Theme</vt:lpstr>
      <vt:lpstr>Prism 8</vt:lpstr>
      <vt:lpstr>Prism 5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School of Medicine, Dentistry &amp; Biomedical Scienc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QUB</dc:creator>
  <cp:lastModifiedBy>Quann, Karen</cp:lastModifiedBy>
  <cp:revision>1446</cp:revision>
  <cp:lastPrinted>2020-11-09T11:42:48Z</cp:lastPrinted>
  <dcterms:created xsi:type="dcterms:W3CDTF">2013-07-19T17:18:10Z</dcterms:created>
  <dcterms:modified xsi:type="dcterms:W3CDTF">2022-03-11T15:49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8604D7B002F574999187FF4BC785067</vt:lpwstr>
  </property>
</Properties>
</file>